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gif" ContentType="image/gi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582" r:id="rId2"/>
  </p:sldIdLst>
  <p:sldSz cx="9144000" cy="6858000" type="screen4x3"/>
  <p:notesSz cx="6797675" cy="9928225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78" userDrawn="1">
          <p15:clr>
            <a:srgbClr val="A4A3A4"/>
          </p15:clr>
        </p15:guide>
        <p15:guide id="4" pos="5511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27" userDrawn="1">
          <p15:clr>
            <a:srgbClr val="A4A3A4"/>
          </p15:clr>
        </p15:guide>
        <p15:guide id="2" pos="2141" userDrawn="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Gioele VISCONTI" initials="GV" lastIdx="3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48235"/>
    <a:srgbClr val="005493"/>
    <a:srgbClr val="005C00"/>
    <a:srgbClr val="007FDE"/>
    <a:srgbClr val="FF3737"/>
    <a:srgbClr val="B7E0FF"/>
    <a:srgbClr val="3BABFF"/>
    <a:srgbClr val="0062AC"/>
    <a:srgbClr val="307C80"/>
    <a:srgbClr val="F5CF2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49" autoAdjust="0"/>
    <p:restoredTop sz="86285" autoAdjust="0"/>
  </p:normalViewPr>
  <p:slideViewPr>
    <p:cSldViewPr>
      <p:cViewPr varScale="1">
        <p:scale>
          <a:sx n="114" d="100"/>
          <a:sy n="114" d="100"/>
        </p:scale>
        <p:origin x="1386" y="84"/>
      </p:cViewPr>
      <p:guideLst>
        <p:guide orient="horz" pos="2478"/>
        <p:guide pos="551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25" d="100"/>
        <a:sy n="125" d="100"/>
      </p:scale>
      <p:origin x="0" y="-6972"/>
    </p:cViewPr>
  </p:sorterViewPr>
  <p:notesViewPr>
    <p:cSldViewPr>
      <p:cViewPr varScale="1">
        <p:scale>
          <a:sx n="101" d="100"/>
          <a:sy n="101" d="100"/>
        </p:scale>
        <p:origin x="2454" y="102"/>
      </p:cViewPr>
      <p:guideLst>
        <p:guide orient="horz" pos="3127"/>
        <p:guide pos="214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epgl\farmadata\Home\Documents\Documents\Projects\Polar%20Projects\Polar%20Compounds%20Analysed\Polar%20Compounds%20Julian\10%20Plasma%20Metabolomics\20200224_Results_NIST_RPLC_ESI+\20200224_Results_NIST_RPLC_ESI+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Number of metabolites by featur'!$B$38</c:f>
              <c:strCache>
                <c:ptCount val="1"/>
                <c:pt idx="0">
                  <c:v>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Number of metabolites by featur'!$A$39:$A$68</c:f>
              <c:strCache>
                <c:ptCount val="30"/>
                <c:pt idx="0">
                  <c:v>IM-AIF Ramp 10-60</c:v>
                </c:pt>
                <c:pt idx="1">
                  <c:v>IM-AIF Ramp 30-60</c:v>
                </c:pt>
                <c:pt idx="2">
                  <c:v>IM-AIF Fixed 14</c:v>
                </c:pt>
                <c:pt idx="3">
                  <c:v>IM-AIF Fixed 28</c:v>
                </c:pt>
                <c:pt idx="4">
                  <c:v>IM-AIF Fixed 56</c:v>
                </c:pt>
                <c:pt idx="5">
                  <c:v>IM-DDA Ramp 10-60 Run 1</c:v>
                </c:pt>
                <c:pt idx="6">
                  <c:v>IM-DDA Ramp 10-60 Run 2</c:v>
                </c:pt>
                <c:pt idx="7">
                  <c:v>IM-DDA Ramp 30-60 Run 1</c:v>
                </c:pt>
                <c:pt idx="8">
                  <c:v>IM-DDA Ramp 30-60 Run 2</c:v>
                </c:pt>
                <c:pt idx="9">
                  <c:v>IM-DDA Fixed 14 Run 1</c:v>
                </c:pt>
                <c:pt idx="10">
                  <c:v>IM-DDA Fixed 14 Run 2</c:v>
                </c:pt>
                <c:pt idx="11">
                  <c:v>IM-DDA Fixed 28 Run 1</c:v>
                </c:pt>
                <c:pt idx="12">
                  <c:v>IM-DDA Fixed 28 Run 2</c:v>
                </c:pt>
                <c:pt idx="13">
                  <c:v>IM-DDA Fixed 56 Run 1</c:v>
                </c:pt>
                <c:pt idx="14">
                  <c:v>IM-DDA Fixed 56 Run 2</c:v>
                </c:pt>
                <c:pt idx="15">
                  <c:v>AIF Ramp 10-60</c:v>
                </c:pt>
                <c:pt idx="16">
                  <c:v>AIF Ramp 30-60</c:v>
                </c:pt>
                <c:pt idx="17">
                  <c:v>AIF Fixed 14</c:v>
                </c:pt>
                <c:pt idx="18">
                  <c:v>AIF Fixed 28</c:v>
                </c:pt>
                <c:pt idx="19">
                  <c:v>AIF Fixed 56</c:v>
                </c:pt>
                <c:pt idx="20">
                  <c:v>DDA Ramp 10-60 Run 1</c:v>
                </c:pt>
                <c:pt idx="21">
                  <c:v>DDA Ramp 10-60 Run 2</c:v>
                </c:pt>
                <c:pt idx="22">
                  <c:v>DDA Ramp 30-60 Run 1</c:v>
                </c:pt>
                <c:pt idx="23">
                  <c:v>DDA Ramp 30-60 Run 2</c:v>
                </c:pt>
                <c:pt idx="24">
                  <c:v>DDA Fixed 14 Run 1</c:v>
                </c:pt>
                <c:pt idx="25">
                  <c:v>DDA Fixed 14 Run 2</c:v>
                </c:pt>
                <c:pt idx="26">
                  <c:v>DDA Fixed 28 Run 1</c:v>
                </c:pt>
                <c:pt idx="27">
                  <c:v>DDA Fixed 28 Run 2</c:v>
                </c:pt>
                <c:pt idx="28">
                  <c:v>DDA Fixed 56 Run 1</c:v>
                </c:pt>
                <c:pt idx="29">
                  <c:v>DDA Fixed 56 Run 2</c:v>
                </c:pt>
              </c:strCache>
            </c:strRef>
          </c:cat>
          <c:val>
            <c:numRef>
              <c:f>'Number of metabolites by featur'!$B$39:$B$68</c:f>
              <c:numCache>
                <c:formatCode>General</c:formatCode>
                <c:ptCount val="30"/>
                <c:pt idx="0">
                  <c:v>35</c:v>
                </c:pt>
                <c:pt idx="1">
                  <c:v>34</c:v>
                </c:pt>
                <c:pt idx="2">
                  <c:v>38</c:v>
                </c:pt>
                <c:pt idx="3">
                  <c:v>31</c:v>
                </c:pt>
                <c:pt idx="4">
                  <c:v>33</c:v>
                </c:pt>
                <c:pt idx="5">
                  <c:v>30</c:v>
                </c:pt>
                <c:pt idx="6">
                  <c:v>24</c:v>
                </c:pt>
                <c:pt idx="7">
                  <c:v>24</c:v>
                </c:pt>
                <c:pt idx="8">
                  <c:v>28</c:v>
                </c:pt>
                <c:pt idx="9">
                  <c:v>24</c:v>
                </c:pt>
                <c:pt idx="10">
                  <c:v>28</c:v>
                </c:pt>
                <c:pt idx="11">
                  <c:v>29</c:v>
                </c:pt>
                <c:pt idx="12">
                  <c:v>22</c:v>
                </c:pt>
                <c:pt idx="13">
                  <c:v>28</c:v>
                </c:pt>
                <c:pt idx="14">
                  <c:v>30</c:v>
                </c:pt>
                <c:pt idx="15">
                  <c:v>52</c:v>
                </c:pt>
                <c:pt idx="16">
                  <c:v>49</c:v>
                </c:pt>
                <c:pt idx="17">
                  <c:v>45</c:v>
                </c:pt>
                <c:pt idx="18">
                  <c:v>57</c:v>
                </c:pt>
                <c:pt idx="19">
                  <c:v>32</c:v>
                </c:pt>
                <c:pt idx="20">
                  <c:v>31</c:v>
                </c:pt>
                <c:pt idx="21">
                  <c:v>16</c:v>
                </c:pt>
                <c:pt idx="22">
                  <c:v>26</c:v>
                </c:pt>
                <c:pt idx="23">
                  <c:v>18</c:v>
                </c:pt>
                <c:pt idx="24">
                  <c:v>25</c:v>
                </c:pt>
                <c:pt idx="25">
                  <c:v>9</c:v>
                </c:pt>
                <c:pt idx="26">
                  <c:v>31</c:v>
                </c:pt>
                <c:pt idx="27">
                  <c:v>14</c:v>
                </c:pt>
                <c:pt idx="28">
                  <c:v>27</c:v>
                </c:pt>
                <c:pt idx="29">
                  <c:v>2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A0E-494A-AB7F-D0CC0A23F60A}"/>
            </c:ext>
          </c:extLst>
        </c:ser>
        <c:ser>
          <c:idx val="1"/>
          <c:order val="1"/>
          <c:tx>
            <c:strRef>
              <c:f>'Number of metabolites by featur'!$C$38</c:f>
              <c:strCache>
                <c:ptCount val="1"/>
                <c:pt idx="0">
                  <c:v>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'Number of metabolites by featur'!$A$39:$A$68</c:f>
              <c:strCache>
                <c:ptCount val="30"/>
                <c:pt idx="0">
                  <c:v>IM-AIF Ramp 10-60</c:v>
                </c:pt>
                <c:pt idx="1">
                  <c:v>IM-AIF Ramp 30-60</c:v>
                </c:pt>
                <c:pt idx="2">
                  <c:v>IM-AIF Fixed 14</c:v>
                </c:pt>
                <c:pt idx="3">
                  <c:v>IM-AIF Fixed 28</c:v>
                </c:pt>
                <c:pt idx="4">
                  <c:v>IM-AIF Fixed 56</c:v>
                </c:pt>
                <c:pt idx="5">
                  <c:v>IM-DDA Ramp 10-60 Run 1</c:v>
                </c:pt>
                <c:pt idx="6">
                  <c:v>IM-DDA Ramp 10-60 Run 2</c:v>
                </c:pt>
                <c:pt idx="7">
                  <c:v>IM-DDA Ramp 30-60 Run 1</c:v>
                </c:pt>
                <c:pt idx="8">
                  <c:v>IM-DDA Ramp 30-60 Run 2</c:v>
                </c:pt>
                <c:pt idx="9">
                  <c:v>IM-DDA Fixed 14 Run 1</c:v>
                </c:pt>
                <c:pt idx="10">
                  <c:v>IM-DDA Fixed 14 Run 2</c:v>
                </c:pt>
                <c:pt idx="11">
                  <c:v>IM-DDA Fixed 28 Run 1</c:v>
                </c:pt>
                <c:pt idx="12">
                  <c:v>IM-DDA Fixed 28 Run 2</c:v>
                </c:pt>
                <c:pt idx="13">
                  <c:v>IM-DDA Fixed 56 Run 1</c:v>
                </c:pt>
                <c:pt idx="14">
                  <c:v>IM-DDA Fixed 56 Run 2</c:v>
                </c:pt>
                <c:pt idx="15">
                  <c:v>AIF Ramp 10-60</c:v>
                </c:pt>
                <c:pt idx="16">
                  <c:v>AIF Ramp 30-60</c:v>
                </c:pt>
                <c:pt idx="17">
                  <c:v>AIF Fixed 14</c:v>
                </c:pt>
                <c:pt idx="18">
                  <c:v>AIF Fixed 28</c:v>
                </c:pt>
                <c:pt idx="19">
                  <c:v>AIF Fixed 56</c:v>
                </c:pt>
                <c:pt idx="20">
                  <c:v>DDA Ramp 10-60 Run 1</c:v>
                </c:pt>
                <c:pt idx="21">
                  <c:v>DDA Ramp 10-60 Run 2</c:v>
                </c:pt>
                <c:pt idx="22">
                  <c:v>DDA Ramp 30-60 Run 1</c:v>
                </c:pt>
                <c:pt idx="23">
                  <c:v>DDA Ramp 30-60 Run 2</c:v>
                </c:pt>
                <c:pt idx="24">
                  <c:v>DDA Fixed 14 Run 1</c:v>
                </c:pt>
                <c:pt idx="25">
                  <c:v>DDA Fixed 14 Run 2</c:v>
                </c:pt>
                <c:pt idx="26">
                  <c:v>DDA Fixed 28 Run 1</c:v>
                </c:pt>
                <c:pt idx="27">
                  <c:v>DDA Fixed 28 Run 2</c:v>
                </c:pt>
                <c:pt idx="28">
                  <c:v>DDA Fixed 56 Run 1</c:v>
                </c:pt>
                <c:pt idx="29">
                  <c:v>DDA Fixed 56 Run 2</c:v>
                </c:pt>
              </c:strCache>
            </c:strRef>
          </c:cat>
          <c:val>
            <c:numRef>
              <c:f>'Number of metabolites by featur'!$C$39:$C$68</c:f>
              <c:numCache>
                <c:formatCode>General</c:formatCode>
                <c:ptCount val="30"/>
                <c:pt idx="0">
                  <c:v>15</c:v>
                </c:pt>
                <c:pt idx="1">
                  <c:v>12</c:v>
                </c:pt>
                <c:pt idx="2">
                  <c:v>7</c:v>
                </c:pt>
                <c:pt idx="3">
                  <c:v>14</c:v>
                </c:pt>
                <c:pt idx="4">
                  <c:v>16</c:v>
                </c:pt>
                <c:pt idx="5">
                  <c:v>9</c:v>
                </c:pt>
                <c:pt idx="6">
                  <c:v>12</c:v>
                </c:pt>
                <c:pt idx="7">
                  <c:v>11</c:v>
                </c:pt>
                <c:pt idx="8">
                  <c:v>12</c:v>
                </c:pt>
                <c:pt idx="9">
                  <c:v>19</c:v>
                </c:pt>
                <c:pt idx="10">
                  <c:v>9</c:v>
                </c:pt>
                <c:pt idx="11">
                  <c:v>13</c:v>
                </c:pt>
                <c:pt idx="12">
                  <c:v>16</c:v>
                </c:pt>
                <c:pt idx="13">
                  <c:v>12</c:v>
                </c:pt>
                <c:pt idx="14">
                  <c:v>12</c:v>
                </c:pt>
                <c:pt idx="15">
                  <c:v>20</c:v>
                </c:pt>
                <c:pt idx="16">
                  <c:v>19</c:v>
                </c:pt>
                <c:pt idx="17">
                  <c:v>12</c:v>
                </c:pt>
                <c:pt idx="18">
                  <c:v>17</c:v>
                </c:pt>
                <c:pt idx="19">
                  <c:v>15</c:v>
                </c:pt>
                <c:pt idx="20">
                  <c:v>12</c:v>
                </c:pt>
                <c:pt idx="21">
                  <c:v>4</c:v>
                </c:pt>
                <c:pt idx="22">
                  <c:v>12</c:v>
                </c:pt>
                <c:pt idx="23">
                  <c:v>5</c:v>
                </c:pt>
                <c:pt idx="24">
                  <c:v>10</c:v>
                </c:pt>
                <c:pt idx="25">
                  <c:v>3</c:v>
                </c:pt>
                <c:pt idx="26">
                  <c:v>11</c:v>
                </c:pt>
                <c:pt idx="27">
                  <c:v>3</c:v>
                </c:pt>
                <c:pt idx="28">
                  <c:v>7</c:v>
                </c:pt>
                <c:pt idx="29">
                  <c:v>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A0E-494A-AB7F-D0CC0A23F60A}"/>
            </c:ext>
          </c:extLst>
        </c:ser>
        <c:ser>
          <c:idx val="2"/>
          <c:order val="2"/>
          <c:tx>
            <c:strRef>
              <c:f>'Number of metabolites by featur'!$D$38</c:f>
              <c:strCache>
                <c:ptCount val="1"/>
                <c:pt idx="0">
                  <c:v>3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strRef>
              <c:f>'Number of metabolites by featur'!$A$39:$A$68</c:f>
              <c:strCache>
                <c:ptCount val="30"/>
                <c:pt idx="0">
                  <c:v>IM-AIF Ramp 10-60</c:v>
                </c:pt>
                <c:pt idx="1">
                  <c:v>IM-AIF Ramp 30-60</c:v>
                </c:pt>
                <c:pt idx="2">
                  <c:v>IM-AIF Fixed 14</c:v>
                </c:pt>
                <c:pt idx="3">
                  <c:v>IM-AIF Fixed 28</c:v>
                </c:pt>
                <c:pt idx="4">
                  <c:v>IM-AIF Fixed 56</c:v>
                </c:pt>
                <c:pt idx="5">
                  <c:v>IM-DDA Ramp 10-60 Run 1</c:v>
                </c:pt>
                <c:pt idx="6">
                  <c:v>IM-DDA Ramp 10-60 Run 2</c:v>
                </c:pt>
                <c:pt idx="7">
                  <c:v>IM-DDA Ramp 30-60 Run 1</c:v>
                </c:pt>
                <c:pt idx="8">
                  <c:v>IM-DDA Ramp 30-60 Run 2</c:v>
                </c:pt>
                <c:pt idx="9">
                  <c:v>IM-DDA Fixed 14 Run 1</c:v>
                </c:pt>
                <c:pt idx="10">
                  <c:v>IM-DDA Fixed 14 Run 2</c:v>
                </c:pt>
                <c:pt idx="11">
                  <c:v>IM-DDA Fixed 28 Run 1</c:v>
                </c:pt>
                <c:pt idx="12">
                  <c:v>IM-DDA Fixed 28 Run 2</c:v>
                </c:pt>
                <c:pt idx="13">
                  <c:v>IM-DDA Fixed 56 Run 1</c:v>
                </c:pt>
                <c:pt idx="14">
                  <c:v>IM-DDA Fixed 56 Run 2</c:v>
                </c:pt>
                <c:pt idx="15">
                  <c:v>AIF Ramp 10-60</c:v>
                </c:pt>
                <c:pt idx="16">
                  <c:v>AIF Ramp 30-60</c:v>
                </c:pt>
                <c:pt idx="17">
                  <c:v>AIF Fixed 14</c:v>
                </c:pt>
                <c:pt idx="18">
                  <c:v>AIF Fixed 28</c:v>
                </c:pt>
                <c:pt idx="19">
                  <c:v>AIF Fixed 56</c:v>
                </c:pt>
                <c:pt idx="20">
                  <c:v>DDA Ramp 10-60 Run 1</c:v>
                </c:pt>
                <c:pt idx="21">
                  <c:v>DDA Ramp 10-60 Run 2</c:v>
                </c:pt>
                <c:pt idx="22">
                  <c:v>DDA Ramp 30-60 Run 1</c:v>
                </c:pt>
                <c:pt idx="23">
                  <c:v>DDA Ramp 30-60 Run 2</c:v>
                </c:pt>
                <c:pt idx="24">
                  <c:v>DDA Fixed 14 Run 1</c:v>
                </c:pt>
                <c:pt idx="25">
                  <c:v>DDA Fixed 14 Run 2</c:v>
                </c:pt>
                <c:pt idx="26">
                  <c:v>DDA Fixed 28 Run 1</c:v>
                </c:pt>
                <c:pt idx="27">
                  <c:v>DDA Fixed 28 Run 2</c:v>
                </c:pt>
                <c:pt idx="28">
                  <c:v>DDA Fixed 56 Run 1</c:v>
                </c:pt>
                <c:pt idx="29">
                  <c:v>DDA Fixed 56 Run 2</c:v>
                </c:pt>
              </c:strCache>
            </c:strRef>
          </c:cat>
          <c:val>
            <c:numRef>
              <c:f>'Number of metabolites by featur'!$D$39:$D$68</c:f>
              <c:numCache>
                <c:formatCode>General</c:formatCode>
                <c:ptCount val="30"/>
                <c:pt idx="0">
                  <c:v>6</c:v>
                </c:pt>
                <c:pt idx="1">
                  <c:v>6</c:v>
                </c:pt>
                <c:pt idx="2">
                  <c:v>2</c:v>
                </c:pt>
                <c:pt idx="3">
                  <c:v>3</c:v>
                </c:pt>
                <c:pt idx="4">
                  <c:v>9</c:v>
                </c:pt>
                <c:pt idx="5">
                  <c:v>8</c:v>
                </c:pt>
                <c:pt idx="6">
                  <c:v>10</c:v>
                </c:pt>
                <c:pt idx="7">
                  <c:v>5</c:v>
                </c:pt>
                <c:pt idx="8">
                  <c:v>11</c:v>
                </c:pt>
                <c:pt idx="9">
                  <c:v>3</c:v>
                </c:pt>
                <c:pt idx="10">
                  <c:v>5</c:v>
                </c:pt>
                <c:pt idx="11">
                  <c:v>6</c:v>
                </c:pt>
                <c:pt idx="12">
                  <c:v>7</c:v>
                </c:pt>
                <c:pt idx="13">
                  <c:v>7</c:v>
                </c:pt>
                <c:pt idx="14">
                  <c:v>9</c:v>
                </c:pt>
                <c:pt idx="15">
                  <c:v>2</c:v>
                </c:pt>
                <c:pt idx="16">
                  <c:v>1</c:v>
                </c:pt>
                <c:pt idx="17">
                  <c:v>0</c:v>
                </c:pt>
                <c:pt idx="18">
                  <c:v>6</c:v>
                </c:pt>
                <c:pt idx="19">
                  <c:v>2</c:v>
                </c:pt>
                <c:pt idx="20">
                  <c:v>2</c:v>
                </c:pt>
                <c:pt idx="21">
                  <c:v>1</c:v>
                </c:pt>
                <c:pt idx="22">
                  <c:v>1</c:v>
                </c:pt>
                <c:pt idx="23">
                  <c:v>0</c:v>
                </c:pt>
                <c:pt idx="24">
                  <c:v>2</c:v>
                </c:pt>
                <c:pt idx="25">
                  <c:v>0</c:v>
                </c:pt>
                <c:pt idx="26">
                  <c:v>6</c:v>
                </c:pt>
                <c:pt idx="27">
                  <c:v>1</c:v>
                </c:pt>
                <c:pt idx="28">
                  <c:v>4</c:v>
                </c:pt>
                <c:pt idx="29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4A0E-494A-AB7F-D0CC0A23F60A}"/>
            </c:ext>
          </c:extLst>
        </c:ser>
        <c:ser>
          <c:idx val="3"/>
          <c:order val="3"/>
          <c:tx>
            <c:strRef>
              <c:f>'Number of metabolites by featur'!$E$38</c:f>
              <c:strCache>
                <c:ptCount val="1"/>
                <c:pt idx="0">
                  <c:v>4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'Number of metabolites by featur'!$A$39:$A$68</c:f>
              <c:strCache>
                <c:ptCount val="30"/>
                <c:pt idx="0">
                  <c:v>IM-AIF Ramp 10-60</c:v>
                </c:pt>
                <c:pt idx="1">
                  <c:v>IM-AIF Ramp 30-60</c:v>
                </c:pt>
                <c:pt idx="2">
                  <c:v>IM-AIF Fixed 14</c:v>
                </c:pt>
                <c:pt idx="3">
                  <c:v>IM-AIF Fixed 28</c:v>
                </c:pt>
                <c:pt idx="4">
                  <c:v>IM-AIF Fixed 56</c:v>
                </c:pt>
                <c:pt idx="5">
                  <c:v>IM-DDA Ramp 10-60 Run 1</c:v>
                </c:pt>
                <c:pt idx="6">
                  <c:v>IM-DDA Ramp 10-60 Run 2</c:v>
                </c:pt>
                <c:pt idx="7">
                  <c:v>IM-DDA Ramp 30-60 Run 1</c:v>
                </c:pt>
                <c:pt idx="8">
                  <c:v>IM-DDA Ramp 30-60 Run 2</c:v>
                </c:pt>
                <c:pt idx="9">
                  <c:v>IM-DDA Fixed 14 Run 1</c:v>
                </c:pt>
                <c:pt idx="10">
                  <c:v>IM-DDA Fixed 14 Run 2</c:v>
                </c:pt>
                <c:pt idx="11">
                  <c:v>IM-DDA Fixed 28 Run 1</c:v>
                </c:pt>
                <c:pt idx="12">
                  <c:v>IM-DDA Fixed 28 Run 2</c:v>
                </c:pt>
                <c:pt idx="13">
                  <c:v>IM-DDA Fixed 56 Run 1</c:v>
                </c:pt>
                <c:pt idx="14">
                  <c:v>IM-DDA Fixed 56 Run 2</c:v>
                </c:pt>
                <c:pt idx="15">
                  <c:v>AIF Ramp 10-60</c:v>
                </c:pt>
                <c:pt idx="16">
                  <c:v>AIF Ramp 30-60</c:v>
                </c:pt>
                <c:pt idx="17">
                  <c:v>AIF Fixed 14</c:v>
                </c:pt>
                <c:pt idx="18">
                  <c:v>AIF Fixed 28</c:v>
                </c:pt>
                <c:pt idx="19">
                  <c:v>AIF Fixed 56</c:v>
                </c:pt>
                <c:pt idx="20">
                  <c:v>DDA Ramp 10-60 Run 1</c:v>
                </c:pt>
                <c:pt idx="21">
                  <c:v>DDA Ramp 10-60 Run 2</c:v>
                </c:pt>
                <c:pt idx="22">
                  <c:v>DDA Ramp 30-60 Run 1</c:v>
                </c:pt>
                <c:pt idx="23">
                  <c:v>DDA Ramp 30-60 Run 2</c:v>
                </c:pt>
                <c:pt idx="24">
                  <c:v>DDA Fixed 14 Run 1</c:v>
                </c:pt>
                <c:pt idx="25">
                  <c:v>DDA Fixed 14 Run 2</c:v>
                </c:pt>
                <c:pt idx="26">
                  <c:v>DDA Fixed 28 Run 1</c:v>
                </c:pt>
                <c:pt idx="27">
                  <c:v>DDA Fixed 28 Run 2</c:v>
                </c:pt>
                <c:pt idx="28">
                  <c:v>DDA Fixed 56 Run 1</c:v>
                </c:pt>
                <c:pt idx="29">
                  <c:v>DDA Fixed 56 Run 2</c:v>
                </c:pt>
              </c:strCache>
            </c:strRef>
          </c:cat>
          <c:val>
            <c:numRef>
              <c:f>'Number of metabolites by featur'!$E$39:$E$68</c:f>
              <c:numCache>
                <c:formatCode>General</c:formatCode>
                <c:ptCount val="30"/>
                <c:pt idx="0">
                  <c:v>1</c:v>
                </c:pt>
                <c:pt idx="1">
                  <c:v>4</c:v>
                </c:pt>
                <c:pt idx="2">
                  <c:v>2</c:v>
                </c:pt>
                <c:pt idx="3">
                  <c:v>4</c:v>
                </c:pt>
                <c:pt idx="4">
                  <c:v>3</c:v>
                </c:pt>
                <c:pt idx="5">
                  <c:v>1</c:v>
                </c:pt>
                <c:pt idx="6">
                  <c:v>4</c:v>
                </c:pt>
                <c:pt idx="7">
                  <c:v>2</c:v>
                </c:pt>
                <c:pt idx="8">
                  <c:v>2</c:v>
                </c:pt>
                <c:pt idx="9">
                  <c:v>4</c:v>
                </c:pt>
                <c:pt idx="10">
                  <c:v>3</c:v>
                </c:pt>
                <c:pt idx="11">
                  <c:v>2</c:v>
                </c:pt>
                <c:pt idx="12">
                  <c:v>4</c:v>
                </c:pt>
                <c:pt idx="13">
                  <c:v>4</c:v>
                </c:pt>
                <c:pt idx="14">
                  <c:v>3</c:v>
                </c:pt>
                <c:pt idx="15">
                  <c:v>5</c:v>
                </c:pt>
                <c:pt idx="16">
                  <c:v>2</c:v>
                </c:pt>
                <c:pt idx="17">
                  <c:v>3</c:v>
                </c:pt>
                <c:pt idx="18">
                  <c:v>5</c:v>
                </c:pt>
                <c:pt idx="19">
                  <c:v>0</c:v>
                </c:pt>
                <c:pt idx="20">
                  <c:v>2</c:v>
                </c:pt>
                <c:pt idx="21">
                  <c:v>0</c:v>
                </c:pt>
                <c:pt idx="22">
                  <c:v>1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2</c:v>
                </c:pt>
                <c:pt idx="27">
                  <c:v>0</c:v>
                </c:pt>
                <c:pt idx="28">
                  <c:v>1</c:v>
                </c:pt>
                <c:pt idx="29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4A0E-494A-AB7F-D0CC0A23F60A}"/>
            </c:ext>
          </c:extLst>
        </c:ser>
        <c:ser>
          <c:idx val="4"/>
          <c:order val="4"/>
          <c:tx>
            <c:strRef>
              <c:f>'Number of metabolites by featur'!$F$38</c:f>
              <c:strCache>
                <c:ptCount val="1"/>
                <c:pt idx="0">
                  <c:v>5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'Number of metabolites by featur'!$A$39:$A$68</c:f>
              <c:strCache>
                <c:ptCount val="30"/>
                <c:pt idx="0">
                  <c:v>IM-AIF Ramp 10-60</c:v>
                </c:pt>
                <c:pt idx="1">
                  <c:v>IM-AIF Ramp 30-60</c:v>
                </c:pt>
                <c:pt idx="2">
                  <c:v>IM-AIF Fixed 14</c:v>
                </c:pt>
                <c:pt idx="3">
                  <c:v>IM-AIF Fixed 28</c:v>
                </c:pt>
                <c:pt idx="4">
                  <c:v>IM-AIF Fixed 56</c:v>
                </c:pt>
                <c:pt idx="5">
                  <c:v>IM-DDA Ramp 10-60 Run 1</c:v>
                </c:pt>
                <c:pt idx="6">
                  <c:v>IM-DDA Ramp 10-60 Run 2</c:v>
                </c:pt>
                <c:pt idx="7">
                  <c:v>IM-DDA Ramp 30-60 Run 1</c:v>
                </c:pt>
                <c:pt idx="8">
                  <c:v>IM-DDA Ramp 30-60 Run 2</c:v>
                </c:pt>
                <c:pt idx="9">
                  <c:v>IM-DDA Fixed 14 Run 1</c:v>
                </c:pt>
                <c:pt idx="10">
                  <c:v>IM-DDA Fixed 14 Run 2</c:v>
                </c:pt>
                <c:pt idx="11">
                  <c:v>IM-DDA Fixed 28 Run 1</c:v>
                </c:pt>
                <c:pt idx="12">
                  <c:v>IM-DDA Fixed 28 Run 2</c:v>
                </c:pt>
                <c:pt idx="13">
                  <c:v>IM-DDA Fixed 56 Run 1</c:v>
                </c:pt>
                <c:pt idx="14">
                  <c:v>IM-DDA Fixed 56 Run 2</c:v>
                </c:pt>
                <c:pt idx="15">
                  <c:v>AIF Ramp 10-60</c:v>
                </c:pt>
                <c:pt idx="16">
                  <c:v>AIF Ramp 30-60</c:v>
                </c:pt>
                <c:pt idx="17">
                  <c:v>AIF Fixed 14</c:v>
                </c:pt>
                <c:pt idx="18">
                  <c:v>AIF Fixed 28</c:v>
                </c:pt>
                <c:pt idx="19">
                  <c:v>AIF Fixed 56</c:v>
                </c:pt>
                <c:pt idx="20">
                  <c:v>DDA Ramp 10-60 Run 1</c:v>
                </c:pt>
                <c:pt idx="21">
                  <c:v>DDA Ramp 10-60 Run 2</c:v>
                </c:pt>
                <c:pt idx="22">
                  <c:v>DDA Ramp 30-60 Run 1</c:v>
                </c:pt>
                <c:pt idx="23">
                  <c:v>DDA Ramp 30-60 Run 2</c:v>
                </c:pt>
                <c:pt idx="24">
                  <c:v>DDA Fixed 14 Run 1</c:v>
                </c:pt>
                <c:pt idx="25">
                  <c:v>DDA Fixed 14 Run 2</c:v>
                </c:pt>
                <c:pt idx="26">
                  <c:v>DDA Fixed 28 Run 1</c:v>
                </c:pt>
                <c:pt idx="27">
                  <c:v>DDA Fixed 28 Run 2</c:v>
                </c:pt>
                <c:pt idx="28">
                  <c:v>DDA Fixed 56 Run 1</c:v>
                </c:pt>
                <c:pt idx="29">
                  <c:v>DDA Fixed 56 Run 2</c:v>
                </c:pt>
              </c:strCache>
            </c:strRef>
          </c:cat>
          <c:val>
            <c:numRef>
              <c:f>'Number of metabolites by featur'!$F$39:$F$68</c:f>
              <c:numCache>
                <c:formatCode>General</c:formatCode>
                <c:ptCount val="30"/>
                <c:pt idx="0">
                  <c:v>3</c:v>
                </c:pt>
                <c:pt idx="1">
                  <c:v>3</c:v>
                </c:pt>
                <c:pt idx="2">
                  <c:v>1</c:v>
                </c:pt>
                <c:pt idx="3">
                  <c:v>3</c:v>
                </c:pt>
                <c:pt idx="4">
                  <c:v>5</c:v>
                </c:pt>
                <c:pt idx="5">
                  <c:v>2</c:v>
                </c:pt>
                <c:pt idx="6">
                  <c:v>2</c:v>
                </c:pt>
                <c:pt idx="7">
                  <c:v>2</c:v>
                </c:pt>
                <c:pt idx="8">
                  <c:v>2</c:v>
                </c:pt>
                <c:pt idx="9">
                  <c:v>3</c:v>
                </c:pt>
                <c:pt idx="10">
                  <c:v>2</c:v>
                </c:pt>
                <c:pt idx="11">
                  <c:v>0</c:v>
                </c:pt>
                <c:pt idx="12">
                  <c:v>3</c:v>
                </c:pt>
                <c:pt idx="13">
                  <c:v>1</c:v>
                </c:pt>
                <c:pt idx="14">
                  <c:v>3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4A0E-494A-AB7F-D0CC0A23F60A}"/>
            </c:ext>
          </c:extLst>
        </c:ser>
        <c:ser>
          <c:idx val="5"/>
          <c:order val="5"/>
          <c:tx>
            <c:strRef>
              <c:f>'Number of metabolites by featur'!$G$38</c:f>
              <c:strCache>
                <c:ptCount val="1"/>
                <c:pt idx="0">
                  <c:v>6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'Number of metabolites by featur'!$A$39:$A$68</c:f>
              <c:strCache>
                <c:ptCount val="30"/>
                <c:pt idx="0">
                  <c:v>IM-AIF Ramp 10-60</c:v>
                </c:pt>
                <c:pt idx="1">
                  <c:v>IM-AIF Ramp 30-60</c:v>
                </c:pt>
                <c:pt idx="2">
                  <c:v>IM-AIF Fixed 14</c:v>
                </c:pt>
                <c:pt idx="3">
                  <c:v>IM-AIF Fixed 28</c:v>
                </c:pt>
                <c:pt idx="4">
                  <c:v>IM-AIF Fixed 56</c:v>
                </c:pt>
                <c:pt idx="5">
                  <c:v>IM-DDA Ramp 10-60 Run 1</c:v>
                </c:pt>
                <c:pt idx="6">
                  <c:v>IM-DDA Ramp 10-60 Run 2</c:v>
                </c:pt>
                <c:pt idx="7">
                  <c:v>IM-DDA Ramp 30-60 Run 1</c:v>
                </c:pt>
                <c:pt idx="8">
                  <c:v>IM-DDA Ramp 30-60 Run 2</c:v>
                </c:pt>
                <c:pt idx="9">
                  <c:v>IM-DDA Fixed 14 Run 1</c:v>
                </c:pt>
                <c:pt idx="10">
                  <c:v>IM-DDA Fixed 14 Run 2</c:v>
                </c:pt>
                <c:pt idx="11">
                  <c:v>IM-DDA Fixed 28 Run 1</c:v>
                </c:pt>
                <c:pt idx="12">
                  <c:v>IM-DDA Fixed 28 Run 2</c:v>
                </c:pt>
                <c:pt idx="13">
                  <c:v>IM-DDA Fixed 56 Run 1</c:v>
                </c:pt>
                <c:pt idx="14">
                  <c:v>IM-DDA Fixed 56 Run 2</c:v>
                </c:pt>
                <c:pt idx="15">
                  <c:v>AIF Ramp 10-60</c:v>
                </c:pt>
                <c:pt idx="16">
                  <c:v>AIF Ramp 30-60</c:v>
                </c:pt>
                <c:pt idx="17">
                  <c:v>AIF Fixed 14</c:v>
                </c:pt>
                <c:pt idx="18">
                  <c:v>AIF Fixed 28</c:v>
                </c:pt>
                <c:pt idx="19">
                  <c:v>AIF Fixed 56</c:v>
                </c:pt>
                <c:pt idx="20">
                  <c:v>DDA Ramp 10-60 Run 1</c:v>
                </c:pt>
                <c:pt idx="21">
                  <c:v>DDA Ramp 10-60 Run 2</c:v>
                </c:pt>
                <c:pt idx="22">
                  <c:v>DDA Ramp 30-60 Run 1</c:v>
                </c:pt>
                <c:pt idx="23">
                  <c:v>DDA Ramp 30-60 Run 2</c:v>
                </c:pt>
                <c:pt idx="24">
                  <c:v>DDA Fixed 14 Run 1</c:v>
                </c:pt>
                <c:pt idx="25">
                  <c:v>DDA Fixed 14 Run 2</c:v>
                </c:pt>
                <c:pt idx="26">
                  <c:v>DDA Fixed 28 Run 1</c:v>
                </c:pt>
                <c:pt idx="27">
                  <c:v>DDA Fixed 28 Run 2</c:v>
                </c:pt>
                <c:pt idx="28">
                  <c:v>DDA Fixed 56 Run 1</c:v>
                </c:pt>
                <c:pt idx="29">
                  <c:v>DDA Fixed 56 Run 2</c:v>
                </c:pt>
              </c:strCache>
            </c:strRef>
          </c:cat>
          <c:val>
            <c:numRef>
              <c:f>'Number of metabolites by featur'!$G$39:$G$68</c:f>
              <c:numCache>
                <c:formatCode>General</c:formatCode>
                <c:ptCount val="3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1</c:v>
                </c:pt>
                <c:pt idx="26">
                  <c:v>1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4A0E-494A-AB7F-D0CC0A23F60A}"/>
            </c:ext>
          </c:extLst>
        </c:ser>
        <c:ser>
          <c:idx val="6"/>
          <c:order val="6"/>
          <c:tx>
            <c:strRef>
              <c:f>'Number of metabolites by featur'!$H$38</c:f>
              <c:strCache>
                <c:ptCount val="1"/>
                <c:pt idx="0">
                  <c:v>7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Number of metabolites by featur'!$A$39:$A$68</c:f>
              <c:strCache>
                <c:ptCount val="30"/>
                <c:pt idx="0">
                  <c:v>IM-AIF Ramp 10-60</c:v>
                </c:pt>
                <c:pt idx="1">
                  <c:v>IM-AIF Ramp 30-60</c:v>
                </c:pt>
                <c:pt idx="2">
                  <c:v>IM-AIF Fixed 14</c:v>
                </c:pt>
                <c:pt idx="3">
                  <c:v>IM-AIF Fixed 28</c:v>
                </c:pt>
                <c:pt idx="4">
                  <c:v>IM-AIF Fixed 56</c:v>
                </c:pt>
                <c:pt idx="5">
                  <c:v>IM-DDA Ramp 10-60 Run 1</c:v>
                </c:pt>
                <c:pt idx="6">
                  <c:v>IM-DDA Ramp 10-60 Run 2</c:v>
                </c:pt>
                <c:pt idx="7">
                  <c:v>IM-DDA Ramp 30-60 Run 1</c:v>
                </c:pt>
                <c:pt idx="8">
                  <c:v>IM-DDA Ramp 30-60 Run 2</c:v>
                </c:pt>
                <c:pt idx="9">
                  <c:v>IM-DDA Fixed 14 Run 1</c:v>
                </c:pt>
                <c:pt idx="10">
                  <c:v>IM-DDA Fixed 14 Run 2</c:v>
                </c:pt>
                <c:pt idx="11">
                  <c:v>IM-DDA Fixed 28 Run 1</c:v>
                </c:pt>
                <c:pt idx="12">
                  <c:v>IM-DDA Fixed 28 Run 2</c:v>
                </c:pt>
                <c:pt idx="13">
                  <c:v>IM-DDA Fixed 56 Run 1</c:v>
                </c:pt>
                <c:pt idx="14">
                  <c:v>IM-DDA Fixed 56 Run 2</c:v>
                </c:pt>
                <c:pt idx="15">
                  <c:v>AIF Ramp 10-60</c:v>
                </c:pt>
                <c:pt idx="16">
                  <c:v>AIF Ramp 30-60</c:v>
                </c:pt>
                <c:pt idx="17">
                  <c:v>AIF Fixed 14</c:v>
                </c:pt>
                <c:pt idx="18">
                  <c:v>AIF Fixed 28</c:v>
                </c:pt>
                <c:pt idx="19">
                  <c:v>AIF Fixed 56</c:v>
                </c:pt>
                <c:pt idx="20">
                  <c:v>DDA Ramp 10-60 Run 1</c:v>
                </c:pt>
                <c:pt idx="21">
                  <c:v>DDA Ramp 10-60 Run 2</c:v>
                </c:pt>
                <c:pt idx="22">
                  <c:v>DDA Ramp 30-60 Run 1</c:v>
                </c:pt>
                <c:pt idx="23">
                  <c:v>DDA Ramp 30-60 Run 2</c:v>
                </c:pt>
                <c:pt idx="24">
                  <c:v>DDA Fixed 14 Run 1</c:v>
                </c:pt>
                <c:pt idx="25">
                  <c:v>DDA Fixed 14 Run 2</c:v>
                </c:pt>
                <c:pt idx="26">
                  <c:v>DDA Fixed 28 Run 1</c:v>
                </c:pt>
                <c:pt idx="27">
                  <c:v>DDA Fixed 28 Run 2</c:v>
                </c:pt>
                <c:pt idx="28">
                  <c:v>DDA Fixed 56 Run 1</c:v>
                </c:pt>
                <c:pt idx="29">
                  <c:v>DDA Fixed 56 Run 2</c:v>
                </c:pt>
              </c:strCache>
            </c:strRef>
          </c:cat>
          <c:val>
            <c:numRef>
              <c:f>'Number of metabolites by featur'!$H$39:$H$68</c:f>
              <c:numCache>
                <c:formatCode>General</c:formatCode>
                <c:ptCount val="30"/>
                <c:pt idx="0">
                  <c:v>1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0</c:v>
                </c:pt>
                <c:pt idx="6">
                  <c:v>0</c:v>
                </c:pt>
                <c:pt idx="7">
                  <c:v>1</c:v>
                </c:pt>
                <c:pt idx="8">
                  <c:v>0</c:v>
                </c:pt>
                <c:pt idx="9">
                  <c:v>1</c:v>
                </c:pt>
                <c:pt idx="10">
                  <c:v>1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4A0E-494A-AB7F-D0CC0A23F60A}"/>
            </c:ext>
          </c:extLst>
        </c:ser>
        <c:ser>
          <c:idx val="7"/>
          <c:order val="7"/>
          <c:tx>
            <c:strRef>
              <c:f>'Number of metabolites by featur'!$I$38</c:f>
              <c:strCache>
                <c:ptCount val="1"/>
                <c:pt idx="0">
                  <c:v>8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Number of metabolites by featur'!$A$39:$A$68</c:f>
              <c:strCache>
                <c:ptCount val="30"/>
                <c:pt idx="0">
                  <c:v>IM-AIF Ramp 10-60</c:v>
                </c:pt>
                <c:pt idx="1">
                  <c:v>IM-AIF Ramp 30-60</c:v>
                </c:pt>
                <c:pt idx="2">
                  <c:v>IM-AIF Fixed 14</c:v>
                </c:pt>
                <c:pt idx="3">
                  <c:v>IM-AIF Fixed 28</c:v>
                </c:pt>
                <c:pt idx="4">
                  <c:v>IM-AIF Fixed 56</c:v>
                </c:pt>
                <c:pt idx="5">
                  <c:v>IM-DDA Ramp 10-60 Run 1</c:v>
                </c:pt>
                <c:pt idx="6">
                  <c:v>IM-DDA Ramp 10-60 Run 2</c:v>
                </c:pt>
                <c:pt idx="7">
                  <c:v>IM-DDA Ramp 30-60 Run 1</c:v>
                </c:pt>
                <c:pt idx="8">
                  <c:v>IM-DDA Ramp 30-60 Run 2</c:v>
                </c:pt>
                <c:pt idx="9">
                  <c:v>IM-DDA Fixed 14 Run 1</c:v>
                </c:pt>
                <c:pt idx="10">
                  <c:v>IM-DDA Fixed 14 Run 2</c:v>
                </c:pt>
                <c:pt idx="11">
                  <c:v>IM-DDA Fixed 28 Run 1</c:v>
                </c:pt>
                <c:pt idx="12">
                  <c:v>IM-DDA Fixed 28 Run 2</c:v>
                </c:pt>
                <c:pt idx="13">
                  <c:v>IM-DDA Fixed 56 Run 1</c:v>
                </c:pt>
                <c:pt idx="14">
                  <c:v>IM-DDA Fixed 56 Run 2</c:v>
                </c:pt>
                <c:pt idx="15">
                  <c:v>AIF Ramp 10-60</c:v>
                </c:pt>
                <c:pt idx="16">
                  <c:v>AIF Ramp 30-60</c:v>
                </c:pt>
                <c:pt idx="17">
                  <c:v>AIF Fixed 14</c:v>
                </c:pt>
                <c:pt idx="18">
                  <c:v>AIF Fixed 28</c:v>
                </c:pt>
                <c:pt idx="19">
                  <c:v>AIF Fixed 56</c:v>
                </c:pt>
                <c:pt idx="20">
                  <c:v>DDA Ramp 10-60 Run 1</c:v>
                </c:pt>
                <c:pt idx="21">
                  <c:v>DDA Ramp 10-60 Run 2</c:v>
                </c:pt>
                <c:pt idx="22">
                  <c:v>DDA Ramp 30-60 Run 1</c:v>
                </c:pt>
                <c:pt idx="23">
                  <c:v>DDA Ramp 30-60 Run 2</c:v>
                </c:pt>
                <c:pt idx="24">
                  <c:v>DDA Fixed 14 Run 1</c:v>
                </c:pt>
                <c:pt idx="25">
                  <c:v>DDA Fixed 14 Run 2</c:v>
                </c:pt>
                <c:pt idx="26">
                  <c:v>DDA Fixed 28 Run 1</c:v>
                </c:pt>
                <c:pt idx="27">
                  <c:v>DDA Fixed 28 Run 2</c:v>
                </c:pt>
                <c:pt idx="28">
                  <c:v>DDA Fixed 56 Run 1</c:v>
                </c:pt>
                <c:pt idx="29">
                  <c:v>DDA Fixed 56 Run 2</c:v>
                </c:pt>
              </c:strCache>
            </c:strRef>
          </c:cat>
          <c:val>
            <c:numRef>
              <c:f>'Number of metabolites by featur'!$I$39:$I$68</c:f>
              <c:numCache>
                <c:formatCode>General</c:formatCode>
                <c:ptCount val="30"/>
                <c:pt idx="0">
                  <c:v>5</c:v>
                </c:pt>
                <c:pt idx="1">
                  <c:v>1</c:v>
                </c:pt>
                <c:pt idx="2">
                  <c:v>3</c:v>
                </c:pt>
                <c:pt idx="3">
                  <c:v>1</c:v>
                </c:pt>
                <c:pt idx="4">
                  <c:v>1</c:v>
                </c:pt>
                <c:pt idx="5">
                  <c:v>2</c:v>
                </c:pt>
                <c:pt idx="6">
                  <c:v>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2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7-4A0E-494A-AB7F-D0CC0A23F60A}"/>
            </c:ext>
          </c:extLst>
        </c:ser>
        <c:ser>
          <c:idx val="8"/>
          <c:order val="8"/>
          <c:tx>
            <c:strRef>
              <c:f>'Number of metabolites by featur'!$J$38</c:f>
              <c:strCache>
                <c:ptCount val="1"/>
                <c:pt idx="0">
                  <c:v>9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Number of metabolites by featur'!$A$39:$A$68</c:f>
              <c:strCache>
                <c:ptCount val="30"/>
                <c:pt idx="0">
                  <c:v>IM-AIF Ramp 10-60</c:v>
                </c:pt>
                <c:pt idx="1">
                  <c:v>IM-AIF Ramp 30-60</c:v>
                </c:pt>
                <c:pt idx="2">
                  <c:v>IM-AIF Fixed 14</c:v>
                </c:pt>
                <c:pt idx="3">
                  <c:v>IM-AIF Fixed 28</c:v>
                </c:pt>
                <c:pt idx="4">
                  <c:v>IM-AIF Fixed 56</c:v>
                </c:pt>
                <c:pt idx="5">
                  <c:v>IM-DDA Ramp 10-60 Run 1</c:v>
                </c:pt>
                <c:pt idx="6">
                  <c:v>IM-DDA Ramp 10-60 Run 2</c:v>
                </c:pt>
                <c:pt idx="7">
                  <c:v>IM-DDA Ramp 30-60 Run 1</c:v>
                </c:pt>
                <c:pt idx="8">
                  <c:v>IM-DDA Ramp 30-60 Run 2</c:v>
                </c:pt>
                <c:pt idx="9">
                  <c:v>IM-DDA Fixed 14 Run 1</c:v>
                </c:pt>
                <c:pt idx="10">
                  <c:v>IM-DDA Fixed 14 Run 2</c:v>
                </c:pt>
                <c:pt idx="11">
                  <c:v>IM-DDA Fixed 28 Run 1</c:v>
                </c:pt>
                <c:pt idx="12">
                  <c:v>IM-DDA Fixed 28 Run 2</c:v>
                </c:pt>
                <c:pt idx="13">
                  <c:v>IM-DDA Fixed 56 Run 1</c:v>
                </c:pt>
                <c:pt idx="14">
                  <c:v>IM-DDA Fixed 56 Run 2</c:v>
                </c:pt>
                <c:pt idx="15">
                  <c:v>AIF Ramp 10-60</c:v>
                </c:pt>
                <c:pt idx="16">
                  <c:v>AIF Ramp 30-60</c:v>
                </c:pt>
                <c:pt idx="17">
                  <c:v>AIF Fixed 14</c:v>
                </c:pt>
                <c:pt idx="18">
                  <c:v>AIF Fixed 28</c:v>
                </c:pt>
                <c:pt idx="19">
                  <c:v>AIF Fixed 56</c:v>
                </c:pt>
                <c:pt idx="20">
                  <c:v>DDA Ramp 10-60 Run 1</c:v>
                </c:pt>
                <c:pt idx="21">
                  <c:v>DDA Ramp 10-60 Run 2</c:v>
                </c:pt>
                <c:pt idx="22">
                  <c:v>DDA Ramp 30-60 Run 1</c:v>
                </c:pt>
                <c:pt idx="23">
                  <c:v>DDA Ramp 30-60 Run 2</c:v>
                </c:pt>
                <c:pt idx="24">
                  <c:v>DDA Fixed 14 Run 1</c:v>
                </c:pt>
                <c:pt idx="25">
                  <c:v>DDA Fixed 14 Run 2</c:v>
                </c:pt>
                <c:pt idx="26">
                  <c:v>DDA Fixed 28 Run 1</c:v>
                </c:pt>
                <c:pt idx="27">
                  <c:v>DDA Fixed 28 Run 2</c:v>
                </c:pt>
                <c:pt idx="28">
                  <c:v>DDA Fixed 56 Run 1</c:v>
                </c:pt>
                <c:pt idx="29">
                  <c:v>DDA Fixed 56 Run 2</c:v>
                </c:pt>
              </c:strCache>
            </c:strRef>
          </c:cat>
          <c:val>
            <c:numRef>
              <c:f>'Number of metabolites by featur'!$J$39:$J$68</c:f>
              <c:numCache>
                <c:formatCode>General</c:formatCode>
                <c:ptCount val="3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4A0E-494A-AB7F-D0CC0A23F60A}"/>
            </c:ext>
          </c:extLst>
        </c:ser>
        <c:ser>
          <c:idx val="9"/>
          <c:order val="9"/>
          <c:tx>
            <c:strRef>
              <c:f>'Number of metabolites by featur'!$K$38</c:f>
              <c:strCache>
                <c:ptCount val="1"/>
                <c:pt idx="0">
                  <c:v>10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Number of metabolites by featur'!$A$39:$A$68</c:f>
              <c:strCache>
                <c:ptCount val="30"/>
                <c:pt idx="0">
                  <c:v>IM-AIF Ramp 10-60</c:v>
                </c:pt>
                <c:pt idx="1">
                  <c:v>IM-AIF Ramp 30-60</c:v>
                </c:pt>
                <c:pt idx="2">
                  <c:v>IM-AIF Fixed 14</c:v>
                </c:pt>
                <c:pt idx="3">
                  <c:v>IM-AIF Fixed 28</c:v>
                </c:pt>
                <c:pt idx="4">
                  <c:v>IM-AIF Fixed 56</c:v>
                </c:pt>
                <c:pt idx="5">
                  <c:v>IM-DDA Ramp 10-60 Run 1</c:v>
                </c:pt>
                <c:pt idx="6">
                  <c:v>IM-DDA Ramp 10-60 Run 2</c:v>
                </c:pt>
                <c:pt idx="7">
                  <c:v>IM-DDA Ramp 30-60 Run 1</c:v>
                </c:pt>
                <c:pt idx="8">
                  <c:v>IM-DDA Ramp 30-60 Run 2</c:v>
                </c:pt>
                <c:pt idx="9">
                  <c:v>IM-DDA Fixed 14 Run 1</c:v>
                </c:pt>
                <c:pt idx="10">
                  <c:v>IM-DDA Fixed 14 Run 2</c:v>
                </c:pt>
                <c:pt idx="11">
                  <c:v>IM-DDA Fixed 28 Run 1</c:v>
                </c:pt>
                <c:pt idx="12">
                  <c:v>IM-DDA Fixed 28 Run 2</c:v>
                </c:pt>
                <c:pt idx="13">
                  <c:v>IM-DDA Fixed 56 Run 1</c:v>
                </c:pt>
                <c:pt idx="14">
                  <c:v>IM-DDA Fixed 56 Run 2</c:v>
                </c:pt>
                <c:pt idx="15">
                  <c:v>AIF Ramp 10-60</c:v>
                </c:pt>
                <c:pt idx="16">
                  <c:v>AIF Ramp 30-60</c:v>
                </c:pt>
                <c:pt idx="17">
                  <c:v>AIF Fixed 14</c:v>
                </c:pt>
                <c:pt idx="18">
                  <c:v>AIF Fixed 28</c:v>
                </c:pt>
                <c:pt idx="19">
                  <c:v>AIF Fixed 56</c:v>
                </c:pt>
                <c:pt idx="20">
                  <c:v>DDA Ramp 10-60 Run 1</c:v>
                </c:pt>
                <c:pt idx="21">
                  <c:v>DDA Ramp 10-60 Run 2</c:v>
                </c:pt>
                <c:pt idx="22">
                  <c:v>DDA Ramp 30-60 Run 1</c:v>
                </c:pt>
                <c:pt idx="23">
                  <c:v>DDA Ramp 30-60 Run 2</c:v>
                </c:pt>
                <c:pt idx="24">
                  <c:v>DDA Fixed 14 Run 1</c:v>
                </c:pt>
                <c:pt idx="25">
                  <c:v>DDA Fixed 14 Run 2</c:v>
                </c:pt>
                <c:pt idx="26">
                  <c:v>DDA Fixed 28 Run 1</c:v>
                </c:pt>
                <c:pt idx="27">
                  <c:v>DDA Fixed 28 Run 2</c:v>
                </c:pt>
                <c:pt idx="28">
                  <c:v>DDA Fixed 56 Run 1</c:v>
                </c:pt>
                <c:pt idx="29">
                  <c:v>DDA Fixed 56 Run 2</c:v>
                </c:pt>
              </c:strCache>
            </c:strRef>
          </c:cat>
          <c:val>
            <c:numRef>
              <c:f>'Number of metabolites by featur'!$K$39:$K$68</c:f>
              <c:numCache>
                <c:formatCode>General</c:formatCode>
                <c:ptCount val="30"/>
                <c:pt idx="0">
                  <c:v>0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9-4A0E-494A-AB7F-D0CC0A23F60A}"/>
            </c:ext>
          </c:extLst>
        </c:ser>
        <c:ser>
          <c:idx val="10"/>
          <c:order val="10"/>
          <c:tx>
            <c:strRef>
              <c:f>'Number of metabolites by featur'!$L$38</c:f>
              <c:strCache>
                <c:ptCount val="1"/>
                <c:pt idx="0">
                  <c:v>11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Number of metabolites by featur'!$A$39:$A$68</c:f>
              <c:strCache>
                <c:ptCount val="30"/>
                <c:pt idx="0">
                  <c:v>IM-AIF Ramp 10-60</c:v>
                </c:pt>
                <c:pt idx="1">
                  <c:v>IM-AIF Ramp 30-60</c:v>
                </c:pt>
                <c:pt idx="2">
                  <c:v>IM-AIF Fixed 14</c:v>
                </c:pt>
                <c:pt idx="3">
                  <c:v>IM-AIF Fixed 28</c:v>
                </c:pt>
                <c:pt idx="4">
                  <c:v>IM-AIF Fixed 56</c:v>
                </c:pt>
                <c:pt idx="5">
                  <c:v>IM-DDA Ramp 10-60 Run 1</c:v>
                </c:pt>
                <c:pt idx="6">
                  <c:v>IM-DDA Ramp 10-60 Run 2</c:v>
                </c:pt>
                <c:pt idx="7">
                  <c:v>IM-DDA Ramp 30-60 Run 1</c:v>
                </c:pt>
                <c:pt idx="8">
                  <c:v>IM-DDA Ramp 30-60 Run 2</c:v>
                </c:pt>
                <c:pt idx="9">
                  <c:v>IM-DDA Fixed 14 Run 1</c:v>
                </c:pt>
                <c:pt idx="10">
                  <c:v>IM-DDA Fixed 14 Run 2</c:v>
                </c:pt>
                <c:pt idx="11">
                  <c:v>IM-DDA Fixed 28 Run 1</c:v>
                </c:pt>
                <c:pt idx="12">
                  <c:v>IM-DDA Fixed 28 Run 2</c:v>
                </c:pt>
                <c:pt idx="13">
                  <c:v>IM-DDA Fixed 56 Run 1</c:v>
                </c:pt>
                <c:pt idx="14">
                  <c:v>IM-DDA Fixed 56 Run 2</c:v>
                </c:pt>
                <c:pt idx="15">
                  <c:v>AIF Ramp 10-60</c:v>
                </c:pt>
                <c:pt idx="16">
                  <c:v>AIF Ramp 30-60</c:v>
                </c:pt>
                <c:pt idx="17">
                  <c:v>AIF Fixed 14</c:v>
                </c:pt>
                <c:pt idx="18">
                  <c:v>AIF Fixed 28</c:v>
                </c:pt>
                <c:pt idx="19">
                  <c:v>AIF Fixed 56</c:v>
                </c:pt>
                <c:pt idx="20">
                  <c:v>DDA Ramp 10-60 Run 1</c:v>
                </c:pt>
                <c:pt idx="21">
                  <c:v>DDA Ramp 10-60 Run 2</c:v>
                </c:pt>
                <c:pt idx="22">
                  <c:v>DDA Ramp 30-60 Run 1</c:v>
                </c:pt>
                <c:pt idx="23">
                  <c:v>DDA Ramp 30-60 Run 2</c:v>
                </c:pt>
                <c:pt idx="24">
                  <c:v>DDA Fixed 14 Run 1</c:v>
                </c:pt>
                <c:pt idx="25">
                  <c:v>DDA Fixed 14 Run 2</c:v>
                </c:pt>
                <c:pt idx="26">
                  <c:v>DDA Fixed 28 Run 1</c:v>
                </c:pt>
                <c:pt idx="27">
                  <c:v>DDA Fixed 28 Run 2</c:v>
                </c:pt>
                <c:pt idx="28">
                  <c:v>DDA Fixed 56 Run 1</c:v>
                </c:pt>
                <c:pt idx="29">
                  <c:v>DDA Fixed 56 Run 2</c:v>
                </c:pt>
              </c:strCache>
            </c:strRef>
          </c:cat>
          <c:val>
            <c:numRef>
              <c:f>'Number of metabolites by featur'!$L$39:$L$68</c:f>
              <c:numCache>
                <c:formatCode>General</c:formatCode>
                <c:ptCount val="3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4A0E-494A-AB7F-D0CC0A23F60A}"/>
            </c:ext>
          </c:extLst>
        </c:ser>
        <c:ser>
          <c:idx val="11"/>
          <c:order val="11"/>
          <c:tx>
            <c:strRef>
              <c:f>'Number of metabolites by featur'!$M$38</c:f>
              <c:strCache>
                <c:ptCount val="1"/>
                <c:pt idx="0">
                  <c:v>12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'Number of metabolites by featur'!$A$39:$A$68</c:f>
              <c:strCache>
                <c:ptCount val="30"/>
                <c:pt idx="0">
                  <c:v>IM-AIF Ramp 10-60</c:v>
                </c:pt>
                <c:pt idx="1">
                  <c:v>IM-AIF Ramp 30-60</c:v>
                </c:pt>
                <c:pt idx="2">
                  <c:v>IM-AIF Fixed 14</c:v>
                </c:pt>
                <c:pt idx="3">
                  <c:v>IM-AIF Fixed 28</c:v>
                </c:pt>
                <c:pt idx="4">
                  <c:v>IM-AIF Fixed 56</c:v>
                </c:pt>
                <c:pt idx="5">
                  <c:v>IM-DDA Ramp 10-60 Run 1</c:v>
                </c:pt>
                <c:pt idx="6">
                  <c:v>IM-DDA Ramp 10-60 Run 2</c:v>
                </c:pt>
                <c:pt idx="7">
                  <c:v>IM-DDA Ramp 30-60 Run 1</c:v>
                </c:pt>
                <c:pt idx="8">
                  <c:v>IM-DDA Ramp 30-60 Run 2</c:v>
                </c:pt>
                <c:pt idx="9">
                  <c:v>IM-DDA Fixed 14 Run 1</c:v>
                </c:pt>
                <c:pt idx="10">
                  <c:v>IM-DDA Fixed 14 Run 2</c:v>
                </c:pt>
                <c:pt idx="11">
                  <c:v>IM-DDA Fixed 28 Run 1</c:v>
                </c:pt>
                <c:pt idx="12">
                  <c:v>IM-DDA Fixed 28 Run 2</c:v>
                </c:pt>
                <c:pt idx="13">
                  <c:v>IM-DDA Fixed 56 Run 1</c:v>
                </c:pt>
                <c:pt idx="14">
                  <c:v>IM-DDA Fixed 56 Run 2</c:v>
                </c:pt>
                <c:pt idx="15">
                  <c:v>AIF Ramp 10-60</c:v>
                </c:pt>
                <c:pt idx="16">
                  <c:v>AIF Ramp 30-60</c:v>
                </c:pt>
                <c:pt idx="17">
                  <c:v>AIF Fixed 14</c:v>
                </c:pt>
                <c:pt idx="18">
                  <c:v>AIF Fixed 28</c:v>
                </c:pt>
                <c:pt idx="19">
                  <c:v>AIF Fixed 56</c:v>
                </c:pt>
                <c:pt idx="20">
                  <c:v>DDA Ramp 10-60 Run 1</c:v>
                </c:pt>
                <c:pt idx="21">
                  <c:v>DDA Ramp 10-60 Run 2</c:v>
                </c:pt>
                <c:pt idx="22">
                  <c:v>DDA Ramp 30-60 Run 1</c:v>
                </c:pt>
                <c:pt idx="23">
                  <c:v>DDA Ramp 30-60 Run 2</c:v>
                </c:pt>
                <c:pt idx="24">
                  <c:v>DDA Fixed 14 Run 1</c:v>
                </c:pt>
                <c:pt idx="25">
                  <c:v>DDA Fixed 14 Run 2</c:v>
                </c:pt>
                <c:pt idx="26">
                  <c:v>DDA Fixed 28 Run 1</c:v>
                </c:pt>
                <c:pt idx="27">
                  <c:v>DDA Fixed 28 Run 2</c:v>
                </c:pt>
                <c:pt idx="28">
                  <c:v>DDA Fixed 56 Run 1</c:v>
                </c:pt>
                <c:pt idx="29">
                  <c:v>DDA Fixed 56 Run 2</c:v>
                </c:pt>
              </c:strCache>
            </c:strRef>
          </c:cat>
          <c:val>
            <c:numRef>
              <c:f>'Number of metabolites by featur'!$M$39:$M$68</c:f>
              <c:numCache>
                <c:formatCode>General</c:formatCode>
                <c:ptCount val="30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1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B-4A0E-494A-AB7F-D0CC0A23F60A}"/>
            </c:ext>
          </c:extLst>
        </c:ser>
        <c:ser>
          <c:idx val="12"/>
          <c:order val="12"/>
          <c:tx>
            <c:strRef>
              <c:f>'Number of metabolites by featur'!$N$38</c:f>
              <c:strCache>
                <c:ptCount val="1"/>
                <c:pt idx="0">
                  <c:v>13</c:v>
                </c:pt>
              </c:strCache>
            </c:strRef>
          </c:tx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Number of metabolites by featur'!$A$39:$A$68</c:f>
              <c:strCache>
                <c:ptCount val="30"/>
                <c:pt idx="0">
                  <c:v>IM-AIF Ramp 10-60</c:v>
                </c:pt>
                <c:pt idx="1">
                  <c:v>IM-AIF Ramp 30-60</c:v>
                </c:pt>
                <c:pt idx="2">
                  <c:v>IM-AIF Fixed 14</c:v>
                </c:pt>
                <c:pt idx="3">
                  <c:v>IM-AIF Fixed 28</c:v>
                </c:pt>
                <c:pt idx="4">
                  <c:v>IM-AIF Fixed 56</c:v>
                </c:pt>
                <c:pt idx="5">
                  <c:v>IM-DDA Ramp 10-60 Run 1</c:v>
                </c:pt>
                <c:pt idx="6">
                  <c:v>IM-DDA Ramp 10-60 Run 2</c:v>
                </c:pt>
                <c:pt idx="7">
                  <c:v>IM-DDA Ramp 30-60 Run 1</c:v>
                </c:pt>
                <c:pt idx="8">
                  <c:v>IM-DDA Ramp 30-60 Run 2</c:v>
                </c:pt>
                <c:pt idx="9">
                  <c:v>IM-DDA Fixed 14 Run 1</c:v>
                </c:pt>
                <c:pt idx="10">
                  <c:v>IM-DDA Fixed 14 Run 2</c:v>
                </c:pt>
                <c:pt idx="11">
                  <c:v>IM-DDA Fixed 28 Run 1</c:v>
                </c:pt>
                <c:pt idx="12">
                  <c:v>IM-DDA Fixed 28 Run 2</c:v>
                </c:pt>
                <c:pt idx="13">
                  <c:v>IM-DDA Fixed 56 Run 1</c:v>
                </c:pt>
                <c:pt idx="14">
                  <c:v>IM-DDA Fixed 56 Run 2</c:v>
                </c:pt>
                <c:pt idx="15">
                  <c:v>AIF Ramp 10-60</c:v>
                </c:pt>
                <c:pt idx="16">
                  <c:v>AIF Ramp 30-60</c:v>
                </c:pt>
                <c:pt idx="17">
                  <c:v>AIF Fixed 14</c:v>
                </c:pt>
                <c:pt idx="18">
                  <c:v>AIF Fixed 28</c:v>
                </c:pt>
                <c:pt idx="19">
                  <c:v>AIF Fixed 56</c:v>
                </c:pt>
                <c:pt idx="20">
                  <c:v>DDA Ramp 10-60 Run 1</c:v>
                </c:pt>
                <c:pt idx="21">
                  <c:v>DDA Ramp 10-60 Run 2</c:v>
                </c:pt>
                <c:pt idx="22">
                  <c:v>DDA Ramp 30-60 Run 1</c:v>
                </c:pt>
                <c:pt idx="23">
                  <c:v>DDA Ramp 30-60 Run 2</c:v>
                </c:pt>
                <c:pt idx="24">
                  <c:v>DDA Fixed 14 Run 1</c:v>
                </c:pt>
                <c:pt idx="25">
                  <c:v>DDA Fixed 14 Run 2</c:v>
                </c:pt>
                <c:pt idx="26">
                  <c:v>DDA Fixed 28 Run 1</c:v>
                </c:pt>
                <c:pt idx="27">
                  <c:v>DDA Fixed 28 Run 2</c:v>
                </c:pt>
                <c:pt idx="28">
                  <c:v>DDA Fixed 56 Run 1</c:v>
                </c:pt>
                <c:pt idx="29">
                  <c:v>DDA Fixed 56 Run 2</c:v>
                </c:pt>
              </c:strCache>
            </c:strRef>
          </c:cat>
          <c:val>
            <c:numRef>
              <c:f>'Number of metabolites by featur'!$N$39:$N$68</c:f>
              <c:numCache>
                <c:formatCode>General</c:formatCode>
                <c:ptCount val="30"/>
                <c:pt idx="0">
                  <c:v>0</c:v>
                </c:pt>
                <c:pt idx="1">
                  <c:v>1</c:v>
                </c:pt>
                <c:pt idx="2">
                  <c:v>0</c:v>
                </c:pt>
                <c:pt idx="3">
                  <c:v>1</c:v>
                </c:pt>
                <c:pt idx="4">
                  <c:v>0</c:v>
                </c:pt>
                <c:pt idx="5">
                  <c:v>0</c:v>
                </c:pt>
                <c:pt idx="6">
                  <c:v>1</c:v>
                </c:pt>
                <c:pt idx="7">
                  <c:v>0</c:v>
                </c:pt>
                <c:pt idx="8">
                  <c:v>1</c:v>
                </c:pt>
                <c:pt idx="9">
                  <c:v>0</c:v>
                </c:pt>
                <c:pt idx="10">
                  <c:v>1</c:v>
                </c:pt>
                <c:pt idx="11">
                  <c:v>1</c:v>
                </c:pt>
                <c:pt idx="12">
                  <c:v>2</c:v>
                </c:pt>
                <c:pt idx="13">
                  <c:v>0</c:v>
                </c:pt>
                <c:pt idx="14">
                  <c:v>2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C-4A0E-494A-AB7F-D0CC0A23F60A}"/>
            </c:ext>
          </c:extLst>
        </c:ser>
        <c:ser>
          <c:idx val="13"/>
          <c:order val="13"/>
          <c:tx>
            <c:strRef>
              <c:f>'Number of metabolites by featur'!$O$38</c:f>
              <c:strCache>
                <c:ptCount val="1"/>
                <c:pt idx="0">
                  <c:v>14</c:v>
                </c:pt>
              </c:strCache>
            </c:strRef>
          </c:tx>
          <c:spPr>
            <a:solidFill>
              <a:schemeClr val="accent2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Number of metabolites by featur'!$A$39:$A$68</c:f>
              <c:strCache>
                <c:ptCount val="30"/>
                <c:pt idx="0">
                  <c:v>IM-AIF Ramp 10-60</c:v>
                </c:pt>
                <c:pt idx="1">
                  <c:v>IM-AIF Ramp 30-60</c:v>
                </c:pt>
                <c:pt idx="2">
                  <c:v>IM-AIF Fixed 14</c:v>
                </c:pt>
                <c:pt idx="3">
                  <c:v>IM-AIF Fixed 28</c:v>
                </c:pt>
                <c:pt idx="4">
                  <c:v>IM-AIF Fixed 56</c:v>
                </c:pt>
                <c:pt idx="5">
                  <c:v>IM-DDA Ramp 10-60 Run 1</c:v>
                </c:pt>
                <c:pt idx="6">
                  <c:v>IM-DDA Ramp 10-60 Run 2</c:v>
                </c:pt>
                <c:pt idx="7">
                  <c:v>IM-DDA Ramp 30-60 Run 1</c:v>
                </c:pt>
                <c:pt idx="8">
                  <c:v>IM-DDA Ramp 30-60 Run 2</c:v>
                </c:pt>
                <c:pt idx="9">
                  <c:v>IM-DDA Fixed 14 Run 1</c:v>
                </c:pt>
                <c:pt idx="10">
                  <c:v>IM-DDA Fixed 14 Run 2</c:v>
                </c:pt>
                <c:pt idx="11">
                  <c:v>IM-DDA Fixed 28 Run 1</c:v>
                </c:pt>
                <c:pt idx="12">
                  <c:v>IM-DDA Fixed 28 Run 2</c:v>
                </c:pt>
                <c:pt idx="13">
                  <c:v>IM-DDA Fixed 56 Run 1</c:v>
                </c:pt>
                <c:pt idx="14">
                  <c:v>IM-DDA Fixed 56 Run 2</c:v>
                </c:pt>
                <c:pt idx="15">
                  <c:v>AIF Ramp 10-60</c:v>
                </c:pt>
                <c:pt idx="16">
                  <c:v>AIF Ramp 30-60</c:v>
                </c:pt>
                <c:pt idx="17">
                  <c:v>AIF Fixed 14</c:v>
                </c:pt>
                <c:pt idx="18">
                  <c:v>AIF Fixed 28</c:v>
                </c:pt>
                <c:pt idx="19">
                  <c:v>AIF Fixed 56</c:v>
                </c:pt>
                <c:pt idx="20">
                  <c:v>DDA Ramp 10-60 Run 1</c:v>
                </c:pt>
                <c:pt idx="21">
                  <c:v>DDA Ramp 10-60 Run 2</c:v>
                </c:pt>
                <c:pt idx="22">
                  <c:v>DDA Ramp 30-60 Run 1</c:v>
                </c:pt>
                <c:pt idx="23">
                  <c:v>DDA Ramp 30-60 Run 2</c:v>
                </c:pt>
                <c:pt idx="24">
                  <c:v>DDA Fixed 14 Run 1</c:v>
                </c:pt>
                <c:pt idx="25">
                  <c:v>DDA Fixed 14 Run 2</c:v>
                </c:pt>
                <c:pt idx="26">
                  <c:v>DDA Fixed 28 Run 1</c:v>
                </c:pt>
                <c:pt idx="27">
                  <c:v>DDA Fixed 28 Run 2</c:v>
                </c:pt>
                <c:pt idx="28">
                  <c:v>DDA Fixed 56 Run 1</c:v>
                </c:pt>
                <c:pt idx="29">
                  <c:v>DDA Fixed 56 Run 2</c:v>
                </c:pt>
              </c:strCache>
            </c:strRef>
          </c:cat>
          <c:val>
            <c:numRef>
              <c:f>'Number of metabolites by featur'!$O$39:$O$68</c:f>
              <c:numCache>
                <c:formatCode>General</c:formatCode>
                <c:ptCount val="3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D-4A0E-494A-AB7F-D0CC0A23F60A}"/>
            </c:ext>
          </c:extLst>
        </c:ser>
        <c:ser>
          <c:idx val="14"/>
          <c:order val="14"/>
          <c:tx>
            <c:strRef>
              <c:f>'Number of metabolites by featur'!$P$38</c:f>
              <c:strCache>
                <c:ptCount val="1"/>
                <c:pt idx="0">
                  <c:v>15</c:v>
                </c:pt>
              </c:strCache>
            </c:strRef>
          </c:tx>
          <c:spPr>
            <a:solidFill>
              <a:schemeClr val="accent3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cat>
            <c:strRef>
              <c:f>'Number of metabolites by featur'!$A$39:$A$68</c:f>
              <c:strCache>
                <c:ptCount val="30"/>
                <c:pt idx="0">
                  <c:v>IM-AIF Ramp 10-60</c:v>
                </c:pt>
                <c:pt idx="1">
                  <c:v>IM-AIF Ramp 30-60</c:v>
                </c:pt>
                <c:pt idx="2">
                  <c:v>IM-AIF Fixed 14</c:v>
                </c:pt>
                <c:pt idx="3">
                  <c:v>IM-AIF Fixed 28</c:v>
                </c:pt>
                <c:pt idx="4">
                  <c:v>IM-AIF Fixed 56</c:v>
                </c:pt>
                <c:pt idx="5">
                  <c:v>IM-DDA Ramp 10-60 Run 1</c:v>
                </c:pt>
                <c:pt idx="6">
                  <c:v>IM-DDA Ramp 10-60 Run 2</c:v>
                </c:pt>
                <c:pt idx="7">
                  <c:v>IM-DDA Ramp 30-60 Run 1</c:v>
                </c:pt>
                <c:pt idx="8">
                  <c:v>IM-DDA Ramp 30-60 Run 2</c:v>
                </c:pt>
                <c:pt idx="9">
                  <c:v>IM-DDA Fixed 14 Run 1</c:v>
                </c:pt>
                <c:pt idx="10">
                  <c:v>IM-DDA Fixed 14 Run 2</c:v>
                </c:pt>
                <c:pt idx="11">
                  <c:v>IM-DDA Fixed 28 Run 1</c:v>
                </c:pt>
                <c:pt idx="12">
                  <c:v>IM-DDA Fixed 28 Run 2</c:v>
                </c:pt>
                <c:pt idx="13">
                  <c:v>IM-DDA Fixed 56 Run 1</c:v>
                </c:pt>
                <c:pt idx="14">
                  <c:v>IM-DDA Fixed 56 Run 2</c:v>
                </c:pt>
                <c:pt idx="15">
                  <c:v>AIF Ramp 10-60</c:v>
                </c:pt>
                <c:pt idx="16">
                  <c:v>AIF Ramp 30-60</c:v>
                </c:pt>
                <c:pt idx="17">
                  <c:v>AIF Fixed 14</c:v>
                </c:pt>
                <c:pt idx="18">
                  <c:v>AIF Fixed 28</c:v>
                </c:pt>
                <c:pt idx="19">
                  <c:v>AIF Fixed 56</c:v>
                </c:pt>
                <c:pt idx="20">
                  <c:v>DDA Ramp 10-60 Run 1</c:v>
                </c:pt>
                <c:pt idx="21">
                  <c:v>DDA Ramp 10-60 Run 2</c:v>
                </c:pt>
                <c:pt idx="22">
                  <c:v>DDA Ramp 30-60 Run 1</c:v>
                </c:pt>
                <c:pt idx="23">
                  <c:v>DDA Ramp 30-60 Run 2</c:v>
                </c:pt>
                <c:pt idx="24">
                  <c:v>DDA Fixed 14 Run 1</c:v>
                </c:pt>
                <c:pt idx="25">
                  <c:v>DDA Fixed 14 Run 2</c:v>
                </c:pt>
                <c:pt idx="26">
                  <c:v>DDA Fixed 28 Run 1</c:v>
                </c:pt>
                <c:pt idx="27">
                  <c:v>DDA Fixed 28 Run 2</c:v>
                </c:pt>
                <c:pt idx="28">
                  <c:v>DDA Fixed 56 Run 1</c:v>
                </c:pt>
                <c:pt idx="29">
                  <c:v>DDA Fixed 56 Run 2</c:v>
                </c:pt>
              </c:strCache>
            </c:strRef>
          </c:cat>
          <c:val>
            <c:numRef>
              <c:f>'Number of metabolites by featur'!$P$39:$P$68</c:f>
              <c:numCache>
                <c:formatCode>General</c:formatCode>
                <c:ptCount val="3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E-4A0E-494A-AB7F-D0CC0A23F6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76220360"/>
        <c:axId val="324675328"/>
      </c:barChart>
      <c:catAx>
        <c:axId val="2762203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4675328"/>
        <c:crosses val="autoZero"/>
        <c:auto val="1"/>
        <c:lblAlgn val="ctr"/>
        <c:lblOffset val="100"/>
        <c:noMultiLvlLbl val="0"/>
      </c:catAx>
      <c:valAx>
        <c:axId val="3246753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62203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10" name="Rectangle 2">
            <a:extLst>
              <a:ext uri="{FF2B5EF4-FFF2-40B4-BE49-F238E27FC236}">
                <a16:creationId xmlns="" xmlns:a16="http://schemas.microsoft.com/office/drawing/2014/main" id="{7148414C-65C6-A246-871F-22E2C938E7F3}"/>
              </a:ext>
            </a:extLst>
          </p:cNvPr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5659" cy="496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 u="none"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3011" name="Rectangle 3">
            <a:extLst>
              <a:ext uri="{FF2B5EF4-FFF2-40B4-BE49-F238E27FC236}">
                <a16:creationId xmlns="" xmlns:a16="http://schemas.microsoft.com/office/drawing/2014/main" id="{B7D175C4-703C-4843-AF1A-9A2C9F1D81A9}"/>
              </a:ext>
            </a:extLst>
          </p:cNvPr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0443" y="0"/>
            <a:ext cx="2945659" cy="496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 u="none"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3012" name="Rectangle 4">
            <a:extLst>
              <a:ext uri="{FF2B5EF4-FFF2-40B4-BE49-F238E27FC236}">
                <a16:creationId xmlns="" xmlns:a16="http://schemas.microsoft.com/office/drawing/2014/main" id="{DCE58E7B-0EE8-3D47-92D6-44DC3FB10794}"/>
              </a:ext>
            </a:extLst>
          </p:cNvPr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30091"/>
            <a:ext cx="2945659" cy="496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 u="none"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3013" name="Rectangle 5">
            <a:extLst>
              <a:ext uri="{FF2B5EF4-FFF2-40B4-BE49-F238E27FC236}">
                <a16:creationId xmlns="" xmlns:a16="http://schemas.microsoft.com/office/drawing/2014/main" id="{7264BDDB-4AB8-9840-B875-097AFB14CDF9}"/>
              </a:ext>
            </a:extLst>
          </p:cNvPr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0443" y="9430091"/>
            <a:ext cx="2945659" cy="496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 u="none" smtClean="0"/>
            </a:lvl1pPr>
          </a:lstStyle>
          <a:p>
            <a:pPr>
              <a:defRPr/>
            </a:pPr>
            <a:fld id="{40A1ED9E-6593-E24E-809B-DCBBD8D6D3D3}" type="slidenum">
              <a:rPr lang="en-US" altLang="en-US"/>
              <a:pPr>
                <a:defRPr/>
              </a:pPr>
              <a:t>‹N°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759541417"/>
      </p:ext>
    </p:extLst>
  </p:cSld>
  <p:clrMap bg1="lt1" tx1="dk1" bg2="lt2" tx2="dk2" accent1="accent1" accent2="accent2" accent3="accent3" accent4="accent4" accent5="accent5" accent6="accent6" hlink="hlink" folHlink="folHlink"/>
  <p:hf hd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Rectangle 2">
            <a:extLst>
              <a:ext uri="{FF2B5EF4-FFF2-40B4-BE49-F238E27FC236}">
                <a16:creationId xmlns="" xmlns:a16="http://schemas.microsoft.com/office/drawing/2014/main" id="{5797589D-82B8-2749-8065-E4CD61ABB653}"/>
              </a:ext>
            </a:extLst>
          </p:cNvPr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5659" cy="496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 u="none"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Rectangle 3">
            <a:extLst>
              <a:ext uri="{FF2B5EF4-FFF2-40B4-BE49-F238E27FC236}">
                <a16:creationId xmlns="" xmlns:a16="http://schemas.microsoft.com/office/drawing/2014/main" id="{F20830BF-2AAF-8A42-BFD8-7D66AD2F4FBD}"/>
              </a:ext>
            </a:extLst>
          </p:cNvPr>
          <p:cNvSpPr>
            <a:spLocks noGrp="1" noChangeArrowheads="1"/>
          </p:cNvSpPr>
          <p:nvPr>
            <p:ph type="dt" idx="1"/>
          </p:nvPr>
        </p:nvSpPr>
        <p:spPr bwMode="auto">
          <a:xfrm>
            <a:off x="3850443" y="0"/>
            <a:ext cx="2945659" cy="496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 u="none"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6" name="Rectangle 4">
            <a:extLst>
              <a:ext uri="{FF2B5EF4-FFF2-40B4-BE49-F238E27FC236}">
                <a16:creationId xmlns="" xmlns:a16="http://schemas.microsoft.com/office/drawing/2014/main" id="{F53A14C8-766D-3A44-A92B-DF5F42C56573}"/>
              </a:ext>
            </a:extLst>
          </p:cNvPr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17575" y="744538"/>
            <a:ext cx="4962525" cy="372268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14341" name="Rectangle 5">
            <a:extLst>
              <a:ext uri="{FF2B5EF4-FFF2-40B4-BE49-F238E27FC236}">
                <a16:creationId xmlns="" xmlns:a16="http://schemas.microsoft.com/office/drawing/2014/main" id="{68420B3D-E15A-EF4E-AFAB-95F6CC3A6C06}"/>
              </a:ext>
            </a:extLst>
          </p:cNvPr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9768" y="4715907"/>
            <a:ext cx="5438140" cy="44677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noProof="0"/>
              <a:t>Cliquez pour modifier les styles du texte du masque</a:t>
            </a:r>
          </a:p>
          <a:p>
            <a:pPr lvl="1"/>
            <a:r>
              <a:rPr lang="en-US" altLang="en-US" noProof="0"/>
              <a:t>Deuxième niveau</a:t>
            </a:r>
          </a:p>
          <a:p>
            <a:pPr lvl="2"/>
            <a:r>
              <a:rPr lang="en-US" altLang="en-US" noProof="0"/>
              <a:t>Troisième niveau</a:t>
            </a:r>
          </a:p>
          <a:p>
            <a:pPr lvl="3"/>
            <a:r>
              <a:rPr lang="en-US" altLang="en-US" noProof="0"/>
              <a:t>Quatrième niveau</a:t>
            </a:r>
          </a:p>
          <a:p>
            <a:pPr lvl="4"/>
            <a:r>
              <a:rPr lang="en-US" altLang="en-US" noProof="0"/>
              <a:t>Cinquième niveau</a:t>
            </a:r>
          </a:p>
        </p:txBody>
      </p:sp>
      <p:sp>
        <p:nvSpPr>
          <p:cNvPr id="14342" name="Rectangle 6">
            <a:extLst>
              <a:ext uri="{FF2B5EF4-FFF2-40B4-BE49-F238E27FC236}">
                <a16:creationId xmlns="" xmlns:a16="http://schemas.microsoft.com/office/drawing/2014/main" id="{4A369B5E-DDA0-2D48-9E5F-ED0B8C2CAFC9}"/>
              </a:ext>
            </a:extLst>
          </p:cNvPr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30091"/>
            <a:ext cx="2945659" cy="496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 u="none"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3" name="Rectangle 7">
            <a:extLst>
              <a:ext uri="{FF2B5EF4-FFF2-40B4-BE49-F238E27FC236}">
                <a16:creationId xmlns="" xmlns:a16="http://schemas.microsoft.com/office/drawing/2014/main" id="{52F273EE-C8EE-3C47-BEBD-9A23FB175F91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50443" y="9430091"/>
            <a:ext cx="2945659" cy="496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 u="none" smtClean="0"/>
            </a:lvl1pPr>
          </a:lstStyle>
          <a:p>
            <a:pPr>
              <a:defRPr/>
            </a:pPr>
            <a:fld id="{4036B3B4-622F-4B49-85C5-268E9955F553}" type="slidenum">
              <a:rPr lang="en-US" altLang="en-US"/>
              <a:pPr>
                <a:defRPr/>
              </a:pPr>
              <a:t>‹N°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281997637"/>
      </p:ext>
    </p:extLst>
  </p:cSld>
  <p:clrMap bg1="lt1" tx1="dk1" bg2="lt2" tx2="dk2" accent1="accent1" accent2="accent2" accent3="accent3" accent4="accent4" accent5="accent5" accent6="accent6" hlink="hlink" folHlink="folHlink"/>
  <p:hf hdr="0" dt="0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CH" dirty="0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pPr>
              <a:defRPr/>
            </a:pPr>
            <a:endParaRPr lang="en-US" alt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pPr>
              <a:defRPr/>
            </a:pPr>
            <a:fld id="{4036B3B4-622F-4B49-85C5-268E9955F553}" type="slidenum">
              <a:rPr lang="en-US" altLang="en-US" smtClean="0"/>
              <a:pPr>
                <a:defRPr/>
              </a:pPr>
              <a:t>1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781431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gif"/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4.png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5" Type="http://schemas.openxmlformats.org/officeDocument/2006/relationships/image" Target="../media/image8.tiff"/><Relationship Id="rId4" Type="http://schemas.openxmlformats.org/officeDocument/2006/relationships/image" Target="../media/image7.png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8">
            <a:extLst>
              <a:ext uri="{FF2B5EF4-FFF2-40B4-BE49-F238E27FC236}">
                <a16:creationId xmlns="" xmlns:a16="http://schemas.microsoft.com/office/drawing/2014/main" id="{C82528AD-258C-C342-98D2-0371DBF2B1CA}"/>
              </a:ext>
            </a:extLst>
          </p:cNvPr>
          <p:cNvSpPr>
            <a:spLocks noChangeArrowheads="1"/>
          </p:cNvSpPr>
          <p:nvPr userDrawn="1"/>
        </p:nvSpPr>
        <p:spPr bwMode="white">
          <a:xfrm>
            <a:off x="1692275" y="0"/>
            <a:ext cx="7451725" cy="68580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n-US" altLang="en-US"/>
          </a:p>
        </p:txBody>
      </p:sp>
      <p:sp>
        <p:nvSpPr>
          <p:cNvPr id="5" name="Rectangle 29">
            <a:extLst>
              <a:ext uri="{FF2B5EF4-FFF2-40B4-BE49-F238E27FC236}">
                <a16:creationId xmlns="" xmlns:a16="http://schemas.microsoft.com/office/drawing/2014/main" id="{CC0FBC91-BFD7-AE47-BAB9-DB9B96205846}"/>
              </a:ext>
            </a:extLst>
          </p:cNvPr>
          <p:cNvSpPr>
            <a:spLocks noChangeArrowheads="1"/>
          </p:cNvSpPr>
          <p:nvPr userDrawn="1"/>
        </p:nvSpPr>
        <p:spPr bwMode="white">
          <a:xfrm>
            <a:off x="0" y="0"/>
            <a:ext cx="1692275" cy="61023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n-US" altLang="en-US"/>
          </a:p>
        </p:txBody>
      </p:sp>
      <p:pic>
        <p:nvPicPr>
          <p:cNvPr id="6" name="Picture 30">
            <a:extLst>
              <a:ext uri="{FF2B5EF4-FFF2-40B4-BE49-F238E27FC236}">
                <a16:creationId xmlns="" xmlns:a16="http://schemas.microsoft.com/office/drawing/2014/main" id="{C92B2677-F4D9-4A4E-ADD2-666B41241066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2" t="60855" r="46706"/>
          <a:stretch>
            <a:fillRect/>
          </a:stretch>
        </p:blipFill>
        <p:spPr bwMode="auto">
          <a:xfrm>
            <a:off x="-9525" y="6092825"/>
            <a:ext cx="1701800" cy="7842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Line 9">
            <a:extLst>
              <a:ext uri="{FF2B5EF4-FFF2-40B4-BE49-F238E27FC236}">
                <a16:creationId xmlns="" xmlns:a16="http://schemas.microsoft.com/office/drawing/2014/main" id="{6449D21B-E394-5548-87EA-638627E20526}"/>
              </a:ext>
            </a:extLst>
          </p:cNvPr>
          <p:cNvSpPr>
            <a:spLocks noChangeShapeType="1"/>
          </p:cNvSpPr>
          <p:nvPr userDrawn="1"/>
        </p:nvSpPr>
        <p:spPr bwMode="auto">
          <a:xfrm>
            <a:off x="360363" y="1052736"/>
            <a:ext cx="8424862" cy="0"/>
          </a:xfrm>
          <a:prstGeom prst="line">
            <a:avLst/>
          </a:prstGeom>
          <a:noFill/>
          <a:ln w="19050">
            <a:solidFill>
              <a:srgbClr val="005493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67591" name="Rectangle 7">
            <a:extLst>
              <a:ext uri="{FF2B5EF4-FFF2-40B4-BE49-F238E27FC236}">
                <a16:creationId xmlns="" xmlns:a16="http://schemas.microsoft.com/office/drawing/2014/main" id="{78FEA650-650A-2A49-AD65-2AA991059D56}"/>
              </a:ext>
            </a:extLst>
          </p:cNvPr>
          <p:cNvSpPr>
            <a:spLocks noGrp="1" noChangeArrowheads="1"/>
          </p:cNvSpPr>
          <p:nvPr>
            <p:ph type="ctrTitle" sz="quarter"/>
          </p:nvPr>
        </p:nvSpPr>
        <p:spPr>
          <a:xfrm>
            <a:off x="685800" y="1598613"/>
            <a:ext cx="7772400" cy="1470025"/>
          </a:xfrm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tx1"/>
                  </a:outerShdw>
                </a:effectLst>
              </a14:hiddenEffects>
            </a:ext>
          </a:extLst>
        </p:spPr>
        <p:txBody>
          <a:bodyPr/>
          <a:lstStyle>
            <a:lvl1pPr algn="ctr">
              <a:defRPr sz="3600" u="sng"/>
            </a:lvl1pPr>
          </a:lstStyle>
          <a:p>
            <a:pPr lvl="0"/>
            <a:r>
              <a:rPr lang="en-US" altLang="en-US" noProof="0" dirty="0" err="1"/>
              <a:t>Titre</a:t>
            </a:r>
            <a:r>
              <a:rPr lang="en-US" altLang="en-US" noProof="0" dirty="0"/>
              <a:t> de la </a:t>
            </a:r>
            <a:r>
              <a:rPr lang="en-US" altLang="en-US" noProof="0" dirty="0" err="1"/>
              <a:t>présentation</a:t>
            </a:r>
            <a:endParaRPr lang="en-US" altLang="en-US" noProof="0" dirty="0"/>
          </a:p>
        </p:txBody>
      </p:sp>
      <p:sp>
        <p:nvSpPr>
          <p:cNvPr id="67592" name="Rectangle 8">
            <a:extLst>
              <a:ext uri="{FF2B5EF4-FFF2-40B4-BE49-F238E27FC236}">
                <a16:creationId xmlns="" xmlns:a16="http://schemas.microsoft.com/office/drawing/2014/main" id="{57E774AC-435D-EB46-9E81-C2489049B4A9}"/>
              </a:ext>
            </a:extLst>
          </p:cNvPr>
          <p:cNvSpPr>
            <a:spLocks noGrp="1" noChangeArrowheads="1"/>
          </p:cNvSpPr>
          <p:nvPr>
            <p:ph type="subTitle" sz="quarter" idx="1"/>
          </p:nvPr>
        </p:nvSpPr>
        <p:spPr bwMode="auto">
          <a:xfrm>
            <a:off x="1371600" y="3981450"/>
            <a:ext cx="6400800" cy="1752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0" indent="0" algn="ctr">
              <a:buFontTx/>
              <a:buNone/>
              <a:defRPr sz="1800" b="1" i="1">
                <a:solidFill>
                  <a:srgbClr val="005493"/>
                </a:solidFill>
              </a:defRPr>
            </a:lvl1pPr>
          </a:lstStyle>
          <a:p>
            <a:pPr lvl="0"/>
            <a:r>
              <a:rPr lang="en-US" altLang="en-US" noProof="0" dirty="0" err="1"/>
              <a:t>Cliquez</a:t>
            </a:r>
            <a:r>
              <a:rPr lang="en-US" altLang="en-US" noProof="0" dirty="0"/>
              <a:t> pour modifier le style des sous-</a:t>
            </a:r>
            <a:r>
              <a:rPr lang="en-US" altLang="en-US" noProof="0" dirty="0" err="1"/>
              <a:t>titres</a:t>
            </a:r>
            <a:r>
              <a:rPr lang="en-US" altLang="en-US" noProof="0" dirty="0"/>
              <a:t> du masque</a:t>
            </a:r>
          </a:p>
        </p:txBody>
      </p:sp>
      <p:sp>
        <p:nvSpPr>
          <p:cNvPr id="15" name="Shape 121"/>
          <p:cNvSpPr/>
          <p:nvPr userDrawn="1"/>
        </p:nvSpPr>
        <p:spPr>
          <a:xfrm>
            <a:off x="-5108" y="6074946"/>
            <a:ext cx="1702800" cy="784800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0306" h="21528" extrusionOk="0">
                <a:moveTo>
                  <a:pt x="0" y="0"/>
                </a:moveTo>
                <a:cubicBezTo>
                  <a:pt x="0" y="0"/>
                  <a:pt x="1977" y="7201"/>
                  <a:pt x="7383" y="13161"/>
                </a:cubicBezTo>
                <a:cubicBezTo>
                  <a:pt x="12790" y="19122"/>
                  <a:pt x="18889" y="21357"/>
                  <a:pt x="20244" y="21478"/>
                </a:cubicBezTo>
                <a:cubicBezTo>
                  <a:pt x="21600" y="21600"/>
                  <a:pt x="72" y="21462"/>
                  <a:pt x="72" y="21462"/>
                </a:cubicBezTo>
                <a:lnTo>
                  <a:pt x="0" y="0"/>
                </a:lnTo>
                <a:close/>
              </a:path>
            </a:pathLst>
          </a:custGeom>
          <a:solidFill>
            <a:srgbClr val="005493"/>
          </a:solidFill>
          <a:ln w="12700">
            <a:solidFill>
              <a:srgbClr val="005493"/>
            </a:solidFill>
            <a:miter lim="400000"/>
          </a:ln>
        </p:spPr>
        <p:txBody>
          <a:bodyPr lIns="50800" tIns="50800" rIns="50800" bIns="50800" anchor="ctr"/>
          <a:lstStyle/>
          <a:p>
            <a:pPr>
              <a:defRPr sz="2400"/>
            </a:pPr>
            <a:endParaRPr/>
          </a:p>
        </p:txBody>
      </p:sp>
      <p:pic>
        <p:nvPicPr>
          <p:cNvPr id="17" name="Image 16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800" y="78165"/>
            <a:ext cx="1877525" cy="900000"/>
          </a:xfrm>
          <a:prstGeom prst="rect">
            <a:avLst/>
          </a:prstGeom>
        </p:spPr>
      </p:pic>
      <p:pic>
        <p:nvPicPr>
          <p:cNvPr id="2" name="Image 1"/>
          <p:cNvPicPr>
            <a:picLocks noChangeAspect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81424" y="24165"/>
            <a:ext cx="1381951" cy="100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738449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ABF629D4-AF02-0E4F-81FC-4E46F0A704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0FC0F27E-6BBB-D94C-AD48-C3574E5338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627719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C0B7E6FA-486A-4B46-A701-0B199BD53BA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911975" y="-22225"/>
            <a:ext cx="2232025" cy="619918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13D848C3-AD5B-7F42-9677-53DC33DBBD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215900" y="-22225"/>
            <a:ext cx="6543675" cy="619918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571934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9FE1A7B5-379E-EA49-8AF2-B9BA4B574F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4DD8D16A-1419-5C48-B020-34731513C4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630969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CD33EDF-65AF-FD41-A793-05C6FABABB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65EF3C3C-0563-4644-A416-5F00EB9C48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pic>
        <p:nvPicPr>
          <p:cNvPr id="4" name="Image 13">
            <a:extLst>
              <a:ext uri="{FF2B5EF4-FFF2-40B4-BE49-F238E27FC236}">
                <a16:creationId xmlns="" xmlns:a16="http://schemas.microsoft.com/office/drawing/2014/main" id="{2C5BE29B-DB7F-C74F-84B5-AAFEB23F1D40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1123" y="122982"/>
            <a:ext cx="1620837" cy="539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Image 16">
            <a:extLst>
              <a:ext uri="{FF2B5EF4-FFF2-40B4-BE49-F238E27FC236}">
                <a16:creationId xmlns="" xmlns:a16="http://schemas.microsoft.com/office/drawing/2014/main" id="{408B3321-9D9D-E644-993F-B3FFA80EFEAA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86623" y="122982"/>
            <a:ext cx="1125537" cy="539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Image 5"/>
          <p:cNvPicPr>
            <a:picLocks noChangeAspect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26790" y="122981"/>
            <a:ext cx="2021674" cy="536575"/>
          </a:xfrm>
          <a:prstGeom prst="rect">
            <a:avLst/>
          </a:prstGeom>
        </p:spPr>
      </p:pic>
      <p:pic>
        <p:nvPicPr>
          <p:cNvPr id="7" name="Picture 15">
            <a:extLst>
              <a:ext uri="{FF2B5EF4-FFF2-40B4-BE49-F238E27FC236}">
                <a16:creationId xmlns="" xmlns:a16="http://schemas.microsoft.com/office/drawing/2014/main" id="{C9F89DD4-84A1-E841-B1C0-E12678A0FFCB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5"/>
          <a:srcRect t="25052" r="39763" b="30949"/>
          <a:stretch/>
        </p:blipFill>
        <p:spPr>
          <a:xfrm>
            <a:off x="519883" y="116632"/>
            <a:ext cx="1384512" cy="5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055082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2072F30B-B48A-8F48-B47F-3E3FB99C33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6E4D3FFA-0688-9844-A41E-0D5D389F513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6715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79C07CEE-CDA1-D346-A481-D86D4D7737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48200" y="1825625"/>
            <a:ext cx="386715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597260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DE2849A-02B5-C24E-B34F-4D2B089394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0238" y="365125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126E960A-C9CD-FD46-A016-F2630E4A09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30238" y="1681163"/>
            <a:ext cx="386873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A3D7A091-6127-4140-AD8A-CF84E3F153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30238" y="2505075"/>
            <a:ext cx="386873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0203AC29-7B9B-594F-94DF-79E8CD2A8FF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7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469402D0-3D24-B74E-9D26-608F55A89EC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7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074442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CA8167DD-F782-BA48-81ED-3524B01117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39410894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4957427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B881066-8CDE-C448-A920-22FBAE18A7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0238" y="457200"/>
            <a:ext cx="294957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4FFEE1EA-F4D0-5F47-BBAB-5F81E65097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788" y="987425"/>
            <a:ext cx="462915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4733257F-09B4-1444-B6BE-E978627826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30238" y="2057400"/>
            <a:ext cx="2949575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025516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1B47EA46-E5D9-A043-84CC-463CB20368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0238" y="457200"/>
            <a:ext cx="294957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3EF81F42-FBEC-704F-AD94-DBCF8FA1226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788" y="987425"/>
            <a:ext cx="462915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F8B3143C-8534-8C43-9012-BCC3C04CCF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30238" y="2057400"/>
            <a:ext cx="2949575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4263338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emf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2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3156C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36">
            <a:extLst>
              <a:ext uri="{FF2B5EF4-FFF2-40B4-BE49-F238E27FC236}">
                <a16:creationId xmlns="" xmlns:a16="http://schemas.microsoft.com/office/drawing/2014/main" id="{8ACCFB54-7CB4-6946-81F7-8A15068CACC4}"/>
              </a:ext>
            </a:extLst>
          </p:cNvPr>
          <p:cNvSpPr>
            <a:spLocks noChangeArrowheads="1"/>
          </p:cNvSpPr>
          <p:nvPr userDrawn="1"/>
        </p:nvSpPr>
        <p:spPr bwMode="white">
          <a:xfrm>
            <a:off x="0" y="0"/>
            <a:ext cx="1692275" cy="61023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n-US" altLang="en-US"/>
          </a:p>
        </p:txBody>
      </p:sp>
      <p:sp>
        <p:nvSpPr>
          <p:cNvPr id="1027" name="Rectangle 37">
            <a:extLst>
              <a:ext uri="{FF2B5EF4-FFF2-40B4-BE49-F238E27FC236}">
                <a16:creationId xmlns="" xmlns:a16="http://schemas.microsoft.com/office/drawing/2014/main" id="{0A9C019F-9B60-264F-96B2-B3F688A3DCAC}"/>
              </a:ext>
            </a:extLst>
          </p:cNvPr>
          <p:cNvSpPr>
            <a:spLocks noChangeArrowheads="1"/>
          </p:cNvSpPr>
          <p:nvPr userDrawn="1"/>
        </p:nvSpPr>
        <p:spPr bwMode="white">
          <a:xfrm>
            <a:off x="1692275" y="0"/>
            <a:ext cx="7451725" cy="68580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n-US" altLang="en-US" dirty="0"/>
          </a:p>
        </p:txBody>
      </p:sp>
      <p:pic>
        <p:nvPicPr>
          <p:cNvPr id="1028" name="Picture 38">
            <a:extLst>
              <a:ext uri="{FF2B5EF4-FFF2-40B4-BE49-F238E27FC236}">
                <a16:creationId xmlns="" xmlns:a16="http://schemas.microsoft.com/office/drawing/2014/main" id="{35318619-A294-134A-882C-270CC51B6CC2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2" t="60855" r="46706"/>
          <a:stretch>
            <a:fillRect/>
          </a:stretch>
        </p:blipFill>
        <p:spPr bwMode="auto">
          <a:xfrm>
            <a:off x="-9525" y="6092825"/>
            <a:ext cx="1701800" cy="784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29" name="Rectangle 22">
            <a:extLst>
              <a:ext uri="{FF2B5EF4-FFF2-40B4-BE49-F238E27FC236}">
                <a16:creationId xmlns="" xmlns:a16="http://schemas.microsoft.com/office/drawing/2014/main" id="{4DC0519E-5609-F44E-950E-1EDEF623C63C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215900" y="-22225"/>
            <a:ext cx="8928100" cy="863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dirty="0" err="1"/>
              <a:t>Cliquez</a:t>
            </a:r>
            <a:r>
              <a:rPr lang="en-US" altLang="en-US" dirty="0"/>
              <a:t> pour modifier le </a:t>
            </a:r>
          </a:p>
        </p:txBody>
      </p:sp>
      <p:sp>
        <p:nvSpPr>
          <p:cNvPr id="9" name="Shape 121"/>
          <p:cNvSpPr/>
          <p:nvPr userDrawn="1"/>
        </p:nvSpPr>
        <p:spPr>
          <a:xfrm>
            <a:off x="-5108" y="6074946"/>
            <a:ext cx="1702800" cy="784800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0306" h="21528" extrusionOk="0">
                <a:moveTo>
                  <a:pt x="0" y="0"/>
                </a:moveTo>
                <a:cubicBezTo>
                  <a:pt x="0" y="0"/>
                  <a:pt x="1977" y="7201"/>
                  <a:pt x="7383" y="13161"/>
                </a:cubicBezTo>
                <a:cubicBezTo>
                  <a:pt x="12790" y="19122"/>
                  <a:pt x="18889" y="21357"/>
                  <a:pt x="20244" y="21478"/>
                </a:cubicBezTo>
                <a:cubicBezTo>
                  <a:pt x="21600" y="21600"/>
                  <a:pt x="72" y="21462"/>
                  <a:pt x="72" y="21462"/>
                </a:cubicBezTo>
                <a:lnTo>
                  <a:pt x="0" y="0"/>
                </a:lnTo>
                <a:close/>
              </a:path>
            </a:pathLst>
          </a:custGeom>
          <a:solidFill>
            <a:srgbClr val="005493"/>
          </a:solidFill>
          <a:ln w="12700">
            <a:solidFill>
              <a:srgbClr val="005493"/>
            </a:solidFill>
            <a:miter lim="400000"/>
          </a:ln>
        </p:spPr>
        <p:txBody>
          <a:bodyPr lIns="50800" tIns="50800" rIns="50800" bIns="50800" anchor="ctr"/>
          <a:lstStyle/>
          <a:p>
            <a:pPr>
              <a:defRPr sz="2400"/>
            </a:pPr>
            <a:endParaRPr/>
          </a:p>
        </p:txBody>
      </p:sp>
      <p:sp>
        <p:nvSpPr>
          <p:cNvPr id="8" name="Espace réservé du numéro de diapositive 6">
            <a:extLst>
              <a:ext uri="{FF2B5EF4-FFF2-40B4-BE49-F238E27FC236}">
                <a16:creationId xmlns="" xmlns:a16="http://schemas.microsoft.com/office/drawing/2014/main" id="{ACC6278D-3D5A-4F43-A9F5-089B921AC093}"/>
              </a:ext>
            </a:extLst>
          </p:cNvPr>
          <p:cNvSpPr txBox="1">
            <a:spLocks/>
          </p:cNvSpPr>
          <p:nvPr userDrawn="1"/>
        </p:nvSpPr>
        <p:spPr>
          <a:xfrm>
            <a:off x="37431" y="6484937"/>
            <a:ext cx="790153" cy="365125"/>
          </a:xfrm>
          <a:prstGeom prst="rect">
            <a:avLst/>
          </a:prstGeom>
        </p:spPr>
        <p:txBody>
          <a:bodyPr/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9pPr>
          </a:lstStyle>
          <a:p>
            <a:fld id="{0EB4E53B-F803-4E3C-A40B-12B1869E2CAE}" type="slidenum">
              <a:rPr lang="fr-CH" b="0" u="none" smtClean="0">
                <a:solidFill>
                  <a:schemeClr val="bg1"/>
                </a:solidFill>
              </a:rPr>
              <a:pPr/>
              <a:t>‹N°›</a:t>
            </a:fld>
            <a:endParaRPr lang="fr-CH" b="0" u="none" dirty="0">
              <a:solidFill>
                <a:schemeClr val="bg1"/>
              </a:solidFill>
            </a:endParaRPr>
          </a:p>
        </p:txBody>
      </p:sp>
      <p:sp>
        <p:nvSpPr>
          <p:cNvPr id="10" name="Shape 146">
            <a:extLst>
              <a:ext uri="{FF2B5EF4-FFF2-40B4-BE49-F238E27FC236}">
                <a16:creationId xmlns="" xmlns:a16="http://schemas.microsoft.com/office/drawing/2014/main" id="{F33188CF-BD96-49D7-BD69-EC93BAF60AC3}"/>
              </a:ext>
            </a:extLst>
          </p:cNvPr>
          <p:cNvSpPr/>
          <p:nvPr userDrawn="1"/>
        </p:nvSpPr>
        <p:spPr>
          <a:xfrm>
            <a:off x="233710" y="764704"/>
            <a:ext cx="8676580" cy="0"/>
          </a:xfrm>
          <a:prstGeom prst="line">
            <a:avLst/>
          </a:prstGeom>
          <a:ln w="19050">
            <a:solidFill>
              <a:srgbClr val="005493"/>
            </a:solidFill>
            <a:miter lim="400000"/>
          </a:ln>
        </p:spPr>
        <p:txBody>
          <a:bodyPr lIns="50800" tIns="50800" rIns="50800" bIns="50800" anchor="ctr"/>
          <a:lstStyle/>
          <a:p>
            <a:pPr>
              <a:defRPr sz="2400"/>
            </a:pPr>
            <a:endParaRPr dirty="0"/>
          </a:p>
        </p:txBody>
      </p:sp>
      <p:pic>
        <p:nvPicPr>
          <p:cNvPr id="11" name="Image 10"/>
          <p:cNvPicPr>
            <a:picLocks noChangeAspect="1"/>
          </p:cNvPicPr>
          <p:nvPr userDrawn="1"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11608" y="160051"/>
            <a:ext cx="1298682" cy="468000"/>
          </a:xfrm>
          <a:prstGeom prst="rect">
            <a:avLst/>
          </a:prstGeom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671" r:id="rId1"/>
    <p:sldLayoutId id="2147483672" r:id="rId2"/>
    <p:sldLayoutId id="2147483673" r:id="rId3"/>
    <p:sldLayoutId id="2147483674" r:id="rId4"/>
    <p:sldLayoutId id="2147483675" r:id="rId5"/>
    <p:sldLayoutId id="2147483676" r:id="rId6"/>
    <p:sldLayoutId id="2147483677" r:id="rId7"/>
    <p:sldLayoutId id="2147483678" r:id="rId8"/>
    <p:sldLayoutId id="2147483679" r:id="rId9"/>
    <p:sldLayoutId id="2147483680" r:id="rId10"/>
    <p:sldLayoutId id="2147483681" r:id="rId11"/>
  </p:sldLayoutIdLst>
  <p:hf hdr="0" ftr="0" dt="0"/>
  <p:txStyles>
    <p:titleStyle>
      <a:lvl1pPr algn="l" rtl="0" eaLnBrk="0" fontAlgn="base" hangingPunct="0">
        <a:spcBef>
          <a:spcPct val="0"/>
        </a:spcBef>
        <a:spcAft>
          <a:spcPct val="0"/>
        </a:spcAft>
        <a:defRPr sz="3200" b="1" kern="1200">
          <a:solidFill>
            <a:srgbClr val="005493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rgbClr val="3156CD"/>
          </a:solidFill>
          <a:latin typeface="Arial" panose="020B0604020202020204" pitchFamily="34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rgbClr val="3156CD"/>
          </a:solidFill>
          <a:latin typeface="Arial" panose="020B0604020202020204" pitchFamily="34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rgbClr val="3156CD"/>
          </a:solidFill>
          <a:latin typeface="Arial" panose="020B0604020202020204" pitchFamily="34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rgbClr val="3156CD"/>
          </a:solidFill>
          <a:latin typeface="Arial" panose="020B0604020202020204" pitchFamily="34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3200" b="1">
          <a:solidFill>
            <a:srgbClr val="3156CD"/>
          </a:solidFill>
          <a:latin typeface="Arial" panose="020B0604020202020204" pitchFamily="34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3200" b="1">
          <a:solidFill>
            <a:srgbClr val="3156CD"/>
          </a:solidFill>
          <a:latin typeface="Arial" panose="020B0604020202020204" pitchFamily="34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3200" b="1">
          <a:solidFill>
            <a:srgbClr val="3156CD"/>
          </a:solidFill>
          <a:latin typeface="Arial" panose="020B0604020202020204" pitchFamily="34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3200" b="1">
          <a:solidFill>
            <a:srgbClr val="3156CD"/>
          </a:solidFill>
          <a:latin typeface="Arial" panose="020B0604020202020204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4">
            <a:extLst>
              <a:ext uri="{FF2B5EF4-FFF2-40B4-BE49-F238E27FC236}">
                <a16:creationId xmlns:a16="http://schemas.microsoft.com/office/drawing/2014/main" xmlns="" id="{537BD600-2992-C743-BFA7-13F419B403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900" y="1689"/>
            <a:ext cx="8928100" cy="7581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3200" b="1" kern="1200">
                <a:solidFill>
                  <a:srgbClr val="005493"/>
                </a:solidFill>
                <a:latin typeface="+mj-lt"/>
                <a:ea typeface="+mj-ea"/>
                <a:cs typeface="+mj-cs"/>
              </a:defRPr>
            </a:lvl1pPr>
            <a:lvl2pPr algn="l" rtl="0" eaLnBrk="0" fontAlgn="base" hangingPunct="0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3156CD"/>
                </a:solidFill>
                <a:latin typeface="Arial" panose="020B0604020202020204" pitchFamily="34" charset="0"/>
              </a:defRPr>
            </a:lvl2pPr>
            <a:lvl3pPr algn="l" rtl="0" eaLnBrk="0" fontAlgn="base" hangingPunct="0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3156CD"/>
                </a:solidFill>
                <a:latin typeface="Arial" panose="020B0604020202020204" pitchFamily="34" charset="0"/>
              </a:defRPr>
            </a:lvl3pPr>
            <a:lvl4pPr algn="l" rtl="0" eaLnBrk="0" fontAlgn="base" hangingPunct="0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3156CD"/>
                </a:solidFill>
                <a:latin typeface="Arial" panose="020B0604020202020204" pitchFamily="34" charset="0"/>
              </a:defRPr>
            </a:lvl4pPr>
            <a:lvl5pPr algn="l" rtl="0" eaLnBrk="0" fontAlgn="base" hangingPunct="0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3156CD"/>
                </a:solidFill>
                <a:latin typeface="Arial" panose="020B0604020202020204" pitchFamily="34" charset="0"/>
              </a:defRPr>
            </a:lvl5pPr>
            <a:lvl6pPr marL="457200" algn="l" rtl="0" fontAlgn="base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3156CD"/>
                </a:solidFill>
                <a:latin typeface="Arial" panose="020B0604020202020204" pitchFamily="34" charset="0"/>
              </a:defRPr>
            </a:lvl6pPr>
            <a:lvl7pPr marL="914400" algn="l" rtl="0" fontAlgn="base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3156CD"/>
                </a:solidFill>
                <a:latin typeface="Arial" panose="020B0604020202020204" pitchFamily="34" charset="0"/>
              </a:defRPr>
            </a:lvl7pPr>
            <a:lvl8pPr marL="1371600" algn="l" rtl="0" fontAlgn="base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3156CD"/>
                </a:solidFill>
                <a:latin typeface="Arial" panose="020B0604020202020204" pitchFamily="34" charset="0"/>
              </a:defRPr>
            </a:lvl8pPr>
            <a:lvl9pPr marL="1828800" algn="l" rtl="0" fontAlgn="base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3156CD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u="none" smtClean="0"/>
              <a:t>Figure S1</a:t>
            </a:r>
          </a:p>
        </p:txBody>
      </p:sp>
      <p:graphicFrame>
        <p:nvGraphicFramePr>
          <p:cNvPr id="6" name="Graphique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40931026"/>
              </p:ext>
            </p:extLst>
          </p:nvPr>
        </p:nvGraphicFramePr>
        <p:xfrm>
          <a:off x="16421" y="895489"/>
          <a:ext cx="9000000" cy="54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" name="ZoneTexte 1"/>
          <p:cNvSpPr txBox="1"/>
          <p:nvPr/>
        </p:nvSpPr>
        <p:spPr>
          <a:xfrm>
            <a:off x="2915754" y="6164684"/>
            <a:ext cx="35283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H" sz="1050" u="none" dirty="0" err="1" smtClean="0"/>
              <a:t>Number</a:t>
            </a:r>
            <a:r>
              <a:rPr lang="fr-CH" sz="1050" u="none" dirty="0" smtClean="0"/>
              <a:t> of </a:t>
            </a:r>
            <a:r>
              <a:rPr lang="fr-CH" sz="1050" u="none" dirty="0" err="1" smtClean="0"/>
              <a:t>proposed</a:t>
            </a:r>
            <a:r>
              <a:rPr lang="fr-CH" sz="1050" u="none" dirty="0" smtClean="0"/>
              <a:t> annotation for one </a:t>
            </a:r>
            <a:r>
              <a:rPr lang="fr-CH" sz="1050" u="none" dirty="0" err="1" smtClean="0"/>
              <a:t>metabolite</a:t>
            </a:r>
            <a:r>
              <a:rPr lang="fr-CH" sz="1050" u="none" dirty="0" smtClean="0"/>
              <a:t> ID</a:t>
            </a:r>
            <a:endParaRPr lang="en-US" sz="1050" u="none" dirty="0"/>
          </a:p>
        </p:txBody>
      </p:sp>
    </p:spTree>
    <p:extLst>
      <p:ext uri="{BB962C8B-B14F-4D97-AF65-F5344CB8AC3E}">
        <p14:creationId xmlns:p14="http://schemas.microsoft.com/office/powerpoint/2010/main" val="2569865352"/>
      </p:ext>
    </p:extLst>
  </p:cSld>
  <p:clrMapOvr>
    <a:masterClrMapping/>
  </p:clrMapOvr>
</p:sld>
</file>

<file path=ppt/theme/theme1.xml><?xml version="1.0" encoding="utf-8"?>
<a:theme xmlns:a="http://schemas.openxmlformats.org/drawingml/2006/main" name="Modèle par défaut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altLang="en-US" sz="1800" b="0" i="0" u="sng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anose="020B0604020202020204" pitchFamily="34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altLang="en-US" sz="1800" b="0" i="0" u="sng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anose="020B0604020202020204" pitchFamily="34" charset="0"/>
          </a:defRPr>
        </a:defPPr>
      </a:lstStyle>
    </a:lnDef>
  </a:objectDefaults>
  <a:extraClrSchemeLst>
    <a:extraClrScheme>
      <a:clrScheme name="Modèle par défaut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58</TotalTime>
  <Words>11</Words>
  <Application>Microsoft Office PowerPoint</Application>
  <PresentationFormat>Affichage à l'écran (4:3)</PresentationFormat>
  <Paragraphs>3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1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3" baseType="lpstr">
      <vt:lpstr>Arial</vt:lpstr>
      <vt:lpstr>Modèle par défaut</vt:lpstr>
      <vt:lpstr>Présentation PowerPoint</vt:lpstr>
    </vt:vector>
  </TitlesOfParts>
  <Manager/>
  <Company>Université de Genève</Company>
  <LinksUpToDate>false</LinksUpToDate>
  <SharedDoc>false</SharedDoc>
  <HyperlinkBase/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subject/>
  <dc:creator>Ivano Marchi</dc:creator>
  <cp:keywords/>
  <dc:description/>
  <cp:lastModifiedBy>Julian PEZZATTI</cp:lastModifiedBy>
  <cp:revision>1105</cp:revision>
  <cp:lastPrinted>2019-10-29T13:11:09Z</cp:lastPrinted>
  <dcterms:created xsi:type="dcterms:W3CDTF">2005-11-09T13:28:07Z</dcterms:created>
  <dcterms:modified xsi:type="dcterms:W3CDTF">2020-09-14T13:59:38Z</dcterms:modified>
  <cp:category/>
</cp:coreProperties>
</file>